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6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Il%20mio%20Drive\ERICA_Drive\articoli\2021\Nota%20ossidata%20caff&#232;\giugno%20capsule%20e%20moka_E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Il%20mio%20Drive\ERICA_Drive\articoli\2021\Nota%20ossidata%20caff&#232;\giugno%20capsule%20e%20moka_E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Il%20mio%20Drive\ERICA_Drive\articoli\2021\Nota%20ossidata%20caff&#232;\giugno%20capsule%20e%20moka_E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G:\Il%20mio%20Drive\ERICA_Drive\articoli\2021\Nota%20ossidata%20caff&#232;\giugno%20capsule%20e%20moka_E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dirty="0" smtClean="0"/>
              <a:t>CV% </a:t>
            </a:r>
            <a:r>
              <a:rPr lang="it-IT" sz="1200" dirty="0" err="1" smtClean="0"/>
              <a:t>between</a:t>
            </a:r>
            <a:r>
              <a:rPr lang="it-IT" sz="1200" dirty="0" smtClean="0"/>
              <a:t> </a:t>
            </a:r>
            <a:r>
              <a:rPr lang="it-IT" sz="1200" dirty="0" err="1"/>
              <a:t>good</a:t>
            </a:r>
            <a:r>
              <a:rPr lang="it-IT" sz="1200" dirty="0"/>
              <a:t> </a:t>
            </a:r>
            <a:r>
              <a:rPr lang="it-IT" sz="1200" i="1" dirty="0"/>
              <a:t>vs</a:t>
            </a:r>
            <a:r>
              <a:rPr lang="it-IT" sz="1200" dirty="0"/>
              <a:t> </a:t>
            </a:r>
            <a:r>
              <a:rPr lang="it-IT" sz="1200" dirty="0" err="1" smtClean="0"/>
              <a:t>oxidised</a:t>
            </a:r>
            <a:r>
              <a:rPr lang="it-IT" sz="1200" dirty="0" smtClean="0"/>
              <a:t> </a:t>
            </a:r>
            <a:r>
              <a:rPr lang="it-IT" sz="1200" dirty="0"/>
              <a:t>(B) </a:t>
            </a:r>
          </a:p>
        </c:rich>
      </c:tx>
      <c:layout>
        <c:manualLayout>
          <c:xMode val="edge"/>
          <c:yMode val="edge"/>
          <c:x val="0.23781455814013611"/>
          <c:y val="5.334726395745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cat>
            <c:strRef>
              <c:f>Bio!$B$161:$B$307</c:f>
              <c:strCache>
                <c:ptCount val="147"/>
                <c:pt idx="0">
                  <c:v>Acetone </c:v>
                </c:pt>
                <c:pt idx="1">
                  <c:v>Methyl acetate </c:v>
                </c:pt>
                <c:pt idx="2">
                  <c:v>Tetrahydrofuran </c:v>
                </c:pt>
                <c:pt idx="3">
                  <c:v>2-Methyl-furan</c:v>
                </c:pt>
                <c:pt idx="4">
                  <c:v> 2,4-Dimethyl-1-heptene</c:v>
                </c:pt>
                <c:pt idx="5">
                  <c:v>2-Butanone</c:v>
                </c:pt>
                <c:pt idx="6">
                  <c:v>2,3-Dihydro-5-methyl-Furane</c:v>
                </c:pt>
                <c:pt idx="7">
                  <c:v>2-Methyl butanal</c:v>
                </c:pt>
                <c:pt idx="8">
                  <c:v>3-Methyl butanal</c:v>
                </c:pt>
                <c:pt idx="9">
                  <c:v>2,5-dimethyl-furane</c:v>
                </c:pt>
                <c:pt idx="10">
                  <c:v>1-Methyl piperidine</c:v>
                </c:pt>
                <c:pt idx="11">
                  <c:v>Unknown 1</c:v>
                </c:pt>
                <c:pt idx="12">
                  <c:v>2,3-Butanedione </c:v>
                </c:pt>
                <c:pt idx="13">
                  <c:v>Methyl 3-methylbutanoate</c:v>
                </c:pt>
                <c:pt idx="14">
                  <c:v>Thiophene </c:v>
                </c:pt>
                <c:pt idx="15">
                  <c:v>N-Methyl-1,2,5,6-tetrahydropyridine</c:v>
                </c:pt>
                <c:pt idx="16">
                  <c:v>3-Hexanone</c:v>
                </c:pt>
                <c:pt idx="17">
                  <c:v>Unknown 2</c:v>
                </c:pt>
                <c:pt idx="18">
                  <c:v>2,3-Pentanedione </c:v>
                </c:pt>
                <c:pt idx="19">
                  <c:v>Dimethyl disulfide</c:v>
                </c:pt>
                <c:pt idx="20">
                  <c:v>4-Vinylfuran</c:v>
                </c:pt>
                <c:pt idx="21">
                  <c:v>Hexanal </c:v>
                </c:pt>
                <c:pt idx="22">
                  <c:v>Tridecanol</c:v>
                </c:pt>
                <c:pt idx="23">
                  <c:v>3,3,5-Trimethyl-1,5-heptadiene</c:v>
                </c:pt>
                <c:pt idx="24">
                  <c:v>4,5-Dimethyl-2-undecene </c:v>
                </c:pt>
                <c:pt idx="25">
                  <c:v>3-penten-2-one</c:v>
                </c:pt>
                <c:pt idx="26">
                  <c:v>2,3-Hexanedione </c:v>
                </c:pt>
                <c:pt idx="27">
                  <c:v>1-Methyl-1H-pyrrole </c:v>
                </c:pt>
                <c:pt idx="28">
                  <c:v>3,4-Hexandione</c:v>
                </c:pt>
                <c:pt idx="29">
                  <c:v>2-Vinyl-5-methylfuran</c:v>
                </c:pt>
                <c:pt idx="30">
                  <c:v>beta-Myrcene</c:v>
                </c:pt>
                <c:pt idx="31">
                  <c:v>Pyridine</c:v>
                </c:pt>
                <c:pt idx="32">
                  <c:v>Limonene</c:v>
                </c:pt>
                <c:pt idx="33">
                  <c:v>Pyrazine </c:v>
                </c:pt>
                <c:pt idx="34">
                  <c:v>Butyl butanoate</c:v>
                </c:pt>
                <c:pt idx="35">
                  <c:v>2-n-Pentylfuran</c:v>
                </c:pt>
                <c:pt idx="36">
                  <c:v>2-Furfuryl methyl ether</c:v>
                </c:pt>
                <c:pt idx="37">
                  <c:v>Thiazole</c:v>
                </c:pt>
                <c:pt idx="38">
                  <c:v>3-Methyl-3-buten-1-ol </c:v>
                </c:pt>
                <c:pt idx="39">
                  <c:v>E-beta Ocimene </c:v>
                </c:pt>
                <c:pt idx="40">
                  <c:v>3-Methyl-2-butenyl acetate</c:v>
                </c:pt>
                <c:pt idx="41">
                  <c:v>Methyl-pyrazine</c:v>
                </c:pt>
                <c:pt idx="42">
                  <c:v>Dihydro-2-methyl-3(2H)-furanone</c:v>
                </c:pt>
                <c:pt idx="43">
                  <c:v>2,5-Dimethyl-1H-pyrrole</c:v>
                </c:pt>
                <c:pt idx="44">
                  <c:v> 3-Hydroxy-2-butanone</c:v>
                </c:pt>
                <c:pt idx="45">
                  <c:v>trans-2-Methyl-5-n-propenylfuran</c:v>
                </c:pt>
                <c:pt idx="46">
                  <c:v>1-Hydroxy-2-propanone</c:v>
                </c:pt>
                <c:pt idx="47">
                  <c:v>2,5-Dimethyl-pyrazine</c:v>
                </c:pt>
                <c:pt idx="48">
                  <c:v>2,6-Dimethyl-pyrazine</c:v>
                </c:pt>
                <c:pt idx="49">
                  <c:v>2-Ethyl-pyrazine </c:v>
                </c:pt>
                <c:pt idx="50">
                  <c:v>2,3-Dimethyl-Pyrazine+2-Hydroxyisobutyric acid  </c:v>
                </c:pt>
                <c:pt idx="51">
                  <c:v>2-Cyclopenten-1-one </c:v>
                </c:pt>
                <c:pt idx="52">
                  <c:v>Unknown 3</c:v>
                </c:pt>
                <c:pt idx="53">
                  <c:v>2-Hydroxy-3-pentanone </c:v>
                </c:pt>
                <c:pt idx="54">
                  <c:v>2-Methyl-2-cyclopenten-1-one </c:v>
                </c:pt>
                <c:pt idx="55">
                  <c:v>2-Ethyl-6-methyl-Pyrazine</c:v>
                </c:pt>
                <c:pt idx="56">
                  <c:v>2-Ethyl-5-methyl-Pyrazine</c:v>
                </c:pt>
                <c:pt idx="57">
                  <c:v>2,3,5-Trimethyl-Pyrazine  </c:v>
                </c:pt>
                <c:pt idx="58">
                  <c:v>2-Ethyl-3-methylpyrazine</c:v>
                </c:pt>
                <c:pt idx="59">
                  <c:v>2-Methyl-3(2H)furanon</c:v>
                </c:pt>
                <c:pt idx="60">
                  <c:v>2-(n-propyl)-Pyrazine</c:v>
                </c:pt>
                <c:pt idx="61">
                  <c:v>2,6-diethyl-Pyrazine</c:v>
                </c:pt>
                <c:pt idx="62">
                  <c:v>2-Furfurylthiol</c:v>
                </c:pt>
                <c:pt idx="63">
                  <c:v>2-ethyl-3,5-dimethyl-Pyrazine</c:v>
                </c:pt>
                <c:pt idx="64">
                  <c:v>Acetic acid </c:v>
                </c:pt>
                <c:pt idx="65">
                  <c:v>2,3-Diethylpyrazine </c:v>
                </c:pt>
                <c:pt idx="66">
                  <c:v>Furfural </c:v>
                </c:pt>
                <c:pt idx="67">
                  <c:v>trans-Linalool oxide</c:v>
                </c:pt>
                <c:pt idx="68">
                  <c:v>Acetoxyacetone</c:v>
                </c:pt>
                <c:pt idx="69">
                  <c:v>2-Methyl-6-vinyl pyrazine</c:v>
                </c:pt>
                <c:pt idx="70">
                  <c:v>Furfuryl methyl sulfide</c:v>
                </c:pt>
                <c:pt idx="71">
                  <c:v>3,5-Diethyl-2-methyl-pyrazine</c:v>
                </c:pt>
                <c:pt idx="72">
                  <c:v>2,5-Dimethyl-3(2H)-furanone</c:v>
                </c:pt>
                <c:pt idx="73">
                  <c:v>2,5-Hexanedione </c:v>
                </c:pt>
                <c:pt idx="74">
                  <c:v>2-Acetylfuran</c:v>
                </c:pt>
                <c:pt idx="75">
                  <c:v>4-Vinyltetrahydro-2H-pyran-2-one</c:v>
                </c:pt>
                <c:pt idx="76">
                  <c:v>1-(2-Furyl)-2-propanone</c:v>
                </c:pt>
                <c:pt idx="77">
                  <c:v>2,3-Dimethyl-2-cyclopenten-1-one </c:v>
                </c:pt>
                <c:pt idx="78">
                  <c:v>2-oxopropyl propanoate</c:v>
                </c:pt>
                <c:pt idx="79">
                  <c:v>1-Acetoxy-2-butanone</c:v>
                </c:pt>
                <c:pt idx="80">
                  <c:v>Furfuryl acetate</c:v>
                </c:pt>
                <c:pt idx="81">
                  <c:v>Propanoic acid </c:v>
                </c:pt>
                <c:pt idx="82">
                  <c:v> 5-Methyl-2-furancarboxaldehyde</c:v>
                </c:pt>
                <c:pt idx="83">
                  <c:v>2-Propionylfuran</c:v>
                </c:pt>
                <c:pt idx="84">
                  <c:v>(5-Methyl-2-furyl)methanethiol</c:v>
                </c:pt>
                <c:pt idx="85">
                  <c:v>(1-methylethenyl)-Pyrazine</c:v>
                </c:pt>
                <c:pt idx="86">
                  <c:v>2-Acetylpyridine</c:v>
                </c:pt>
                <c:pt idx="87">
                  <c:v>Furfuryl propanoate</c:v>
                </c:pt>
                <c:pt idx="88">
                  <c:v>5H-5-Methyl-6,7-dihydrocyclopentapyrazine</c:v>
                </c:pt>
                <c:pt idx="89">
                  <c:v>1-methyl 1H-Pyrrole-2-carboxaldehyde</c:v>
                </c:pt>
                <c:pt idx="90">
                  <c:v>4-hydroxy-butanoic acid</c:v>
                </c:pt>
                <c:pt idx="91">
                  <c:v>2-Isopropenylpyrazine</c:v>
                </c:pt>
                <c:pt idx="92">
                  <c:v>Butanoic acid</c:v>
                </c:pt>
                <c:pt idx="93">
                  <c:v>2,5-dihydro-3,5-dimethyl-2-Furanone</c:v>
                </c:pt>
                <c:pt idx="94">
                  <c:v>1-(2-Furyl)-butan-3-one </c:v>
                </c:pt>
                <c:pt idx="95">
                  <c:v>2-Acetyl-1-methylpyrrole</c:v>
                </c:pt>
                <c:pt idx="96">
                  <c:v>3-Mercapto-3-methyl-1-butanol</c:v>
                </c:pt>
                <c:pt idx="97">
                  <c:v>Furfuryl alcohol</c:v>
                </c:pt>
                <c:pt idx="98">
                  <c:v>3-Ethyl-2-hydroxy-2-cyclopenten-1-one</c:v>
                </c:pt>
                <c:pt idx="99">
                  <c:v>3-Methyl-butanoic acid</c:v>
                </c:pt>
                <c:pt idx="100">
                  <c:v>2-Furfuryl-5-methylfuran</c:v>
                </c:pt>
                <c:pt idx="101">
                  <c:v>Acetyl-6-methylpyrazine</c:v>
                </c:pt>
                <c:pt idx="102">
                  <c:v>Unknown 4</c:v>
                </c:pt>
                <c:pt idx="103">
                  <c:v>Unknown 5</c:v>
                </c:pt>
                <c:pt idx="104">
                  <c:v>N-acetyl-4(H)-Pyridine</c:v>
                </c:pt>
                <c:pt idx="105">
                  <c:v>3-Methoxy-2-methyl-cyclohex-2-enone</c:v>
                </c:pt>
                <c:pt idx="106">
                  <c:v>3-ethyl-4-methyl-2,5-Furandione</c:v>
                </c:pt>
                <c:pt idx="107">
                  <c:v>2(5H)-Furanone</c:v>
                </c:pt>
                <c:pt idx="108">
                  <c:v>Methyl salicylate</c:v>
                </c:pt>
                <c:pt idx="109">
                  <c:v>Unknown 6</c:v>
                </c:pt>
                <c:pt idx="110">
                  <c:v>Unknown 7</c:v>
                </c:pt>
                <c:pt idx="111">
                  <c:v>3,5-DIMETHYL CYCLOPENTENOLONE</c:v>
                </c:pt>
                <c:pt idx="112">
                  <c:v>Unknown 8</c:v>
                </c:pt>
                <c:pt idx="113">
                  <c:v>3-methyl-2-Butenoic acid</c:v>
                </c:pt>
                <c:pt idx="114">
                  <c:v>Unknown 9</c:v>
                </c:pt>
                <c:pt idx="115">
                  <c:v>2-hydroxy-3-methyl-2-Cyclopenten-1-one </c:v>
                </c:pt>
                <c:pt idx="116">
                  <c:v>1-(2-furanylmethyl)-1H-Pyrrole </c:v>
                </c:pt>
                <c:pt idx="117">
                  <c:v>Unknown 10</c:v>
                </c:pt>
                <c:pt idx="118">
                  <c:v>n-butylbenzoate</c:v>
                </c:pt>
                <c:pt idx="119">
                  <c:v>2-methoxy-Phenol </c:v>
                </c:pt>
                <c:pt idx="120">
                  <c:v>Unknown 11</c:v>
                </c:pt>
                <c:pt idx="121">
                  <c:v>3-ethyl-2-hydroxy- 2-Cyclopenten-1-one</c:v>
                </c:pt>
                <c:pt idx="122">
                  <c:v>Unknown 12</c:v>
                </c:pt>
                <c:pt idx="123">
                  <c:v>Phenylethyl Alcohol </c:v>
                </c:pt>
                <c:pt idx="124">
                  <c:v>2-Thiophenemethanol</c:v>
                </c:pt>
                <c:pt idx="125">
                  <c:v>Maltol </c:v>
                </c:pt>
                <c:pt idx="126">
                  <c:v>2-Acetylpyrrole</c:v>
                </c:pt>
                <c:pt idx="127">
                  <c:v>4(1H)-Quinazolinone </c:v>
                </c:pt>
                <c:pt idx="128">
                  <c:v>Difurfuryl ether</c:v>
                </c:pt>
                <c:pt idx="129">
                  <c:v>4-Hydroxy-3-methylacetophenone</c:v>
                </c:pt>
                <c:pt idx="130">
                  <c:v>Phenol </c:v>
                </c:pt>
                <c:pt idx="131">
                  <c:v>1H-Pyrrole-2-carboxaldehyde</c:v>
                </c:pt>
                <c:pt idx="132">
                  <c:v>4-ethyl guaiacol</c:v>
                </c:pt>
                <c:pt idx="133">
                  <c:v>2,5-Dimethyl-4-hydroxy-3(2H)-furanone (Furaneol)</c:v>
                </c:pt>
                <c:pt idx="134">
                  <c:v>5-Acetyldihydro-2(3H)-furanone (Solerone)</c:v>
                </c:pt>
                <c:pt idx="135">
                  <c:v>N-Methyl-2-formylpyrrol</c:v>
                </c:pt>
                <c:pt idx="136">
                  <c:v>Unknown 13</c:v>
                </c:pt>
                <c:pt idx="137">
                  <c:v>Nonanoic acid </c:v>
                </c:pt>
                <c:pt idx="138">
                  <c:v>2-Vinyl guaiacol</c:v>
                </c:pt>
                <c:pt idx="139">
                  <c:v>Unknown 14</c:v>
                </c:pt>
                <c:pt idx="140">
                  <c:v>n-Decanoic acid </c:v>
                </c:pt>
                <c:pt idx="141">
                  <c:v>2-Benzofuran-1(3H)-one</c:v>
                </c:pt>
                <c:pt idx="142">
                  <c:v>2,3-dihydro-Benzofuran</c:v>
                </c:pt>
                <c:pt idx="143">
                  <c:v>Unknown 15</c:v>
                </c:pt>
                <c:pt idx="144">
                  <c:v>Indole</c:v>
                </c:pt>
                <c:pt idx="145">
                  <c:v>Benzoic acid</c:v>
                </c:pt>
                <c:pt idx="146">
                  <c:v>5-(Hydroxymethyl)dihydro-2(3H)-furanone</c:v>
                </c:pt>
              </c:strCache>
            </c:strRef>
          </c:cat>
          <c:val>
            <c:numRef>
              <c:f>Bio!$N$161:$N$307</c:f>
              <c:numCache>
                <c:formatCode>0.0</c:formatCode>
                <c:ptCount val="147"/>
                <c:pt idx="0">
                  <c:v>21.5010461810413</c:v>
                </c:pt>
                <c:pt idx="1">
                  <c:v>31.445246912266821</c:v>
                </c:pt>
                <c:pt idx="2">
                  <c:v>-49.013453068577611</c:v>
                </c:pt>
                <c:pt idx="3">
                  <c:v>19.612273245520345</c:v>
                </c:pt>
                <c:pt idx="4">
                  <c:v>0</c:v>
                </c:pt>
                <c:pt idx="5">
                  <c:v>53.260892016588471</c:v>
                </c:pt>
                <c:pt idx="6">
                  <c:v>23.619952207875645</c:v>
                </c:pt>
                <c:pt idx="7">
                  <c:v>6.2486939887291646</c:v>
                </c:pt>
                <c:pt idx="8">
                  <c:v>-34.47618661935293</c:v>
                </c:pt>
                <c:pt idx="9">
                  <c:v>6.6192666462754124</c:v>
                </c:pt>
                <c:pt idx="10">
                  <c:v>-88.104461652762623</c:v>
                </c:pt>
                <c:pt idx="11">
                  <c:v>32.649148626753956</c:v>
                </c:pt>
                <c:pt idx="12">
                  <c:v>-70.201630559743705</c:v>
                </c:pt>
                <c:pt idx="13">
                  <c:v>-0.84851491649824229</c:v>
                </c:pt>
                <c:pt idx="14">
                  <c:v>-41.936207231936358</c:v>
                </c:pt>
                <c:pt idx="15">
                  <c:v>-87.968270346545864</c:v>
                </c:pt>
                <c:pt idx="16">
                  <c:v>16.551222071150992</c:v>
                </c:pt>
                <c:pt idx="17">
                  <c:v>-6.6625003505313956</c:v>
                </c:pt>
                <c:pt idx="18">
                  <c:v>-54.213381162663133</c:v>
                </c:pt>
                <c:pt idx="19">
                  <c:v>64.47627234712165</c:v>
                </c:pt>
                <c:pt idx="20">
                  <c:v>-27.205398556832211</c:v>
                </c:pt>
                <c:pt idx="21">
                  <c:v>-63.170999993306467</c:v>
                </c:pt>
                <c:pt idx="22">
                  <c:v>0</c:v>
                </c:pt>
                <c:pt idx="23">
                  <c:v>0</c:v>
                </c:pt>
                <c:pt idx="24">
                  <c:v>-13.397344114096407</c:v>
                </c:pt>
                <c:pt idx="25">
                  <c:v>-79.312002125653194</c:v>
                </c:pt>
                <c:pt idx="26">
                  <c:v>-44.120496437198668</c:v>
                </c:pt>
                <c:pt idx="27">
                  <c:v>-37.862043704614337</c:v>
                </c:pt>
                <c:pt idx="28">
                  <c:v>-28.390857320893836</c:v>
                </c:pt>
                <c:pt idx="29">
                  <c:v>-32.722259028092573</c:v>
                </c:pt>
                <c:pt idx="30">
                  <c:v>-17.860988971229851</c:v>
                </c:pt>
                <c:pt idx="31">
                  <c:v>0.29219583907000285</c:v>
                </c:pt>
                <c:pt idx="32">
                  <c:v>19.099113627249636</c:v>
                </c:pt>
                <c:pt idx="33">
                  <c:v>18.494723360900242</c:v>
                </c:pt>
                <c:pt idx="34">
                  <c:v>38.131113676408056</c:v>
                </c:pt>
                <c:pt idx="35">
                  <c:v>-39.785688101830182</c:v>
                </c:pt>
                <c:pt idx="36">
                  <c:v>4.0159567234782347</c:v>
                </c:pt>
                <c:pt idx="37">
                  <c:v>28.638076041556143</c:v>
                </c:pt>
                <c:pt idx="38">
                  <c:v>2.2729033080669327</c:v>
                </c:pt>
                <c:pt idx="39">
                  <c:v>-18.075541773292102</c:v>
                </c:pt>
                <c:pt idx="40">
                  <c:v>-16.603903284616994</c:v>
                </c:pt>
                <c:pt idx="41">
                  <c:v>1.1969460116263664</c:v>
                </c:pt>
                <c:pt idx="42">
                  <c:v>18.003898391786276</c:v>
                </c:pt>
                <c:pt idx="43">
                  <c:v>-95.093643833438534</c:v>
                </c:pt>
                <c:pt idx="44">
                  <c:v>48.606039885150487</c:v>
                </c:pt>
                <c:pt idx="45">
                  <c:v>-6.9268783464460704</c:v>
                </c:pt>
                <c:pt idx="46">
                  <c:v>21.221054689197043</c:v>
                </c:pt>
                <c:pt idx="47">
                  <c:v>-15.170283428998516</c:v>
                </c:pt>
                <c:pt idx="48">
                  <c:v>-14.269930061420435</c:v>
                </c:pt>
                <c:pt idx="49">
                  <c:v>-10.168798234248491</c:v>
                </c:pt>
                <c:pt idx="50">
                  <c:v>-21.0507483949328</c:v>
                </c:pt>
                <c:pt idx="51">
                  <c:v>-73.265204040144667</c:v>
                </c:pt>
                <c:pt idx="52">
                  <c:v>2.4402243294923074</c:v>
                </c:pt>
                <c:pt idx="53">
                  <c:v>19.006348739087649</c:v>
                </c:pt>
                <c:pt idx="54">
                  <c:v>7.4946585043812322</c:v>
                </c:pt>
                <c:pt idx="55">
                  <c:v>-19.380328871788564</c:v>
                </c:pt>
                <c:pt idx="56">
                  <c:v>-18.768229755434682</c:v>
                </c:pt>
                <c:pt idx="57">
                  <c:v>-2.9619300532723183</c:v>
                </c:pt>
                <c:pt idx="58">
                  <c:v>-19.532580610896304</c:v>
                </c:pt>
                <c:pt idx="59">
                  <c:v>-77.489823002251612</c:v>
                </c:pt>
                <c:pt idx="60">
                  <c:v>-22.987062408004874</c:v>
                </c:pt>
                <c:pt idx="61">
                  <c:v>-23.188984712665174</c:v>
                </c:pt>
                <c:pt idx="62">
                  <c:v>-100</c:v>
                </c:pt>
                <c:pt idx="63">
                  <c:v>-28.818788587060357</c:v>
                </c:pt>
                <c:pt idx="64">
                  <c:v>89.608987386904246</c:v>
                </c:pt>
                <c:pt idx="65">
                  <c:v>-22.8871264618755</c:v>
                </c:pt>
                <c:pt idx="66">
                  <c:v>-38.450818639160971</c:v>
                </c:pt>
                <c:pt idx="67">
                  <c:v>-31.535996171057434</c:v>
                </c:pt>
                <c:pt idx="68">
                  <c:v>4.8648673739301502</c:v>
                </c:pt>
                <c:pt idx="69">
                  <c:v>-68.667394968324288</c:v>
                </c:pt>
                <c:pt idx="70">
                  <c:v>4.8861762164951976</c:v>
                </c:pt>
                <c:pt idx="71">
                  <c:v>-30.106018544687078</c:v>
                </c:pt>
                <c:pt idx="72">
                  <c:v>-31.166369546044887</c:v>
                </c:pt>
                <c:pt idx="73">
                  <c:v>9.3362555354644297</c:v>
                </c:pt>
                <c:pt idx="74">
                  <c:v>27.112225601673622</c:v>
                </c:pt>
                <c:pt idx="75">
                  <c:v>-94.019397523030051</c:v>
                </c:pt>
                <c:pt idx="76">
                  <c:v>18.426687649597966</c:v>
                </c:pt>
                <c:pt idx="77">
                  <c:v>-7.8185783353843741</c:v>
                </c:pt>
                <c:pt idx="78">
                  <c:v>-3.1023144387776993</c:v>
                </c:pt>
                <c:pt idx="79">
                  <c:v>-1.2952933482776934</c:v>
                </c:pt>
                <c:pt idx="80">
                  <c:v>10.407926238319568</c:v>
                </c:pt>
                <c:pt idx="81">
                  <c:v>103.40688910686117</c:v>
                </c:pt>
                <c:pt idx="82">
                  <c:v>-5.6835116331297177</c:v>
                </c:pt>
                <c:pt idx="83">
                  <c:v>12.048070299789289</c:v>
                </c:pt>
                <c:pt idx="84">
                  <c:v>9.0671926078520713</c:v>
                </c:pt>
                <c:pt idx="85">
                  <c:v>-16.990849263975065</c:v>
                </c:pt>
                <c:pt idx="86">
                  <c:v>-0.69910315131236511</c:v>
                </c:pt>
                <c:pt idx="87">
                  <c:v>18.522840474505326</c:v>
                </c:pt>
                <c:pt idx="88">
                  <c:v>-23.7995941831301</c:v>
                </c:pt>
                <c:pt idx="89">
                  <c:v>4.6325732648320095</c:v>
                </c:pt>
                <c:pt idx="90">
                  <c:v>41.487205218038675</c:v>
                </c:pt>
                <c:pt idx="91">
                  <c:v>-24.961098784198729</c:v>
                </c:pt>
                <c:pt idx="92">
                  <c:v>0</c:v>
                </c:pt>
                <c:pt idx="93">
                  <c:v>9.754200532575739</c:v>
                </c:pt>
                <c:pt idx="94">
                  <c:v>4.8100306685489809</c:v>
                </c:pt>
                <c:pt idx="95">
                  <c:v>-6.5445625852241491</c:v>
                </c:pt>
                <c:pt idx="96">
                  <c:v>-43.62900859046934</c:v>
                </c:pt>
                <c:pt idx="97">
                  <c:v>25.401213406119048</c:v>
                </c:pt>
                <c:pt idx="98">
                  <c:v>-2.9524073399284969</c:v>
                </c:pt>
                <c:pt idx="99">
                  <c:v>-1.3842952049675801</c:v>
                </c:pt>
                <c:pt idx="100">
                  <c:v>0</c:v>
                </c:pt>
                <c:pt idx="101">
                  <c:v>-12.865620560288843</c:v>
                </c:pt>
                <c:pt idx="102">
                  <c:v>-23.748566331243239</c:v>
                </c:pt>
                <c:pt idx="103">
                  <c:v>-3.1203376247284487</c:v>
                </c:pt>
                <c:pt idx="104">
                  <c:v>-16.853958111466106</c:v>
                </c:pt>
                <c:pt idx="105">
                  <c:v>-13.637039026696621</c:v>
                </c:pt>
                <c:pt idx="106">
                  <c:v>-13.298852385156101</c:v>
                </c:pt>
                <c:pt idx="107">
                  <c:v>0</c:v>
                </c:pt>
                <c:pt idx="108">
                  <c:v>0</c:v>
                </c:pt>
                <c:pt idx="109">
                  <c:v>-28.16354308658337</c:v>
                </c:pt>
                <c:pt idx="110">
                  <c:v>-76.205372027019834</c:v>
                </c:pt>
                <c:pt idx="111">
                  <c:v>-6.8403523918742266</c:v>
                </c:pt>
                <c:pt idx="112">
                  <c:v>-14.181232298241708</c:v>
                </c:pt>
                <c:pt idx="113">
                  <c:v>0</c:v>
                </c:pt>
                <c:pt idx="114">
                  <c:v>-2.2818621690147629</c:v>
                </c:pt>
                <c:pt idx="115">
                  <c:v>11.018871192265809</c:v>
                </c:pt>
                <c:pt idx="116">
                  <c:v>-3.2057841249885874</c:v>
                </c:pt>
                <c:pt idx="117">
                  <c:v>3.1899246184960353</c:v>
                </c:pt>
                <c:pt idx="118">
                  <c:v>-51.13365293090758</c:v>
                </c:pt>
                <c:pt idx="119">
                  <c:v>5.1903530349404026</c:v>
                </c:pt>
                <c:pt idx="120">
                  <c:v>-19.463063589137025</c:v>
                </c:pt>
                <c:pt idx="121">
                  <c:v>-1.8486480332002022</c:v>
                </c:pt>
                <c:pt idx="122">
                  <c:v>-31.578279743461824</c:v>
                </c:pt>
                <c:pt idx="123">
                  <c:v>-27.433237628209351</c:v>
                </c:pt>
                <c:pt idx="124">
                  <c:v>16.147966677154006</c:v>
                </c:pt>
                <c:pt idx="125">
                  <c:v>28.832616815310551</c:v>
                </c:pt>
                <c:pt idx="126">
                  <c:v>25.788492725850009</c:v>
                </c:pt>
                <c:pt idx="127">
                  <c:v>-8.3981961079213043</c:v>
                </c:pt>
                <c:pt idx="128">
                  <c:v>8.0420954435930181</c:v>
                </c:pt>
                <c:pt idx="129">
                  <c:v>-5.0457953086058982</c:v>
                </c:pt>
                <c:pt idx="130">
                  <c:v>38.425061009972445</c:v>
                </c:pt>
                <c:pt idx="131">
                  <c:v>59.468191929774314</c:v>
                </c:pt>
                <c:pt idx="132">
                  <c:v>-16.101870590652187</c:v>
                </c:pt>
                <c:pt idx="133">
                  <c:v>-51.506764820379736</c:v>
                </c:pt>
                <c:pt idx="134">
                  <c:v>-18.081806815477591</c:v>
                </c:pt>
                <c:pt idx="135">
                  <c:v>34.05236927030483</c:v>
                </c:pt>
                <c:pt idx="136">
                  <c:v>-12.072143413022406</c:v>
                </c:pt>
                <c:pt idx="137">
                  <c:v>-71.372949139875644</c:v>
                </c:pt>
                <c:pt idx="138">
                  <c:v>-44.667507419285748</c:v>
                </c:pt>
                <c:pt idx="139">
                  <c:v>3.2936204460585405</c:v>
                </c:pt>
                <c:pt idx="140">
                  <c:v>-49.045110796531866</c:v>
                </c:pt>
                <c:pt idx="141">
                  <c:v>-53.082583270398196</c:v>
                </c:pt>
                <c:pt idx="142">
                  <c:v>-40.421270297416989</c:v>
                </c:pt>
                <c:pt idx="143">
                  <c:v>0</c:v>
                </c:pt>
                <c:pt idx="144">
                  <c:v>-12.200316987756764</c:v>
                </c:pt>
                <c:pt idx="145">
                  <c:v>0</c:v>
                </c:pt>
                <c:pt idx="146">
                  <c:v>71.3785768677944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6F-4289-8C31-E72F10186C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197118719"/>
        <c:axId val="1197117471"/>
      </c:barChart>
      <c:catAx>
        <c:axId val="1197118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97117471"/>
        <c:crosses val="autoZero"/>
        <c:auto val="1"/>
        <c:lblAlgn val="ctr"/>
        <c:lblOffset val="100"/>
        <c:noMultiLvlLbl val="0"/>
      </c:catAx>
      <c:valAx>
        <c:axId val="11971174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197118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dirty="0" smtClean="0"/>
              <a:t>CV% </a:t>
            </a:r>
            <a:r>
              <a:rPr lang="it-IT" sz="1200" dirty="0" err="1" smtClean="0"/>
              <a:t>between</a:t>
            </a:r>
            <a:r>
              <a:rPr lang="it-IT" sz="1200" dirty="0" smtClean="0"/>
              <a:t> </a:t>
            </a:r>
            <a:r>
              <a:rPr lang="it-IT" sz="1200" dirty="0" err="1"/>
              <a:t>good</a:t>
            </a:r>
            <a:r>
              <a:rPr lang="it-IT" sz="1200" dirty="0"/>
              <a:t> </a:t>
            </a:r>
            <a:r>
              <a:rPr lang="it-IT" sz="1200" i="1" dirty="0"/>
              <a:t>vs</a:t>
            </a:r>
            <a:r>
              <a:rPr lang="it-IT" sz="1200" dirty="0"/>
              <a:t> </a:t>
            </a:r>
            <a:r>
              <a:rPr lang="it-IT" sz="1200" dirty="0" err="1" smtClean="0"/>
              <a:t>oxidised</a:t>
            </a:r>
            <a:r>
              <a:rPr lang="it-IT" sz="1200" dirty="0" smtClean="0"/>
              <a:t> </a:t>
            </a:r>
            <a:r>
              <a:rPr lang="it-IT" sz="1200" dirty="0"/>
              <a:t>(P) </a:t>
            </a:r>
          </a:p>
        </c:rich>
      </c:tx>
      <c:layout>
        <c:manualLayout>
          <c:xMode val="edge"/>
          <c:yMode val="edge"/>
          <c:x val="0.23823138943820865"/>
          <c:y val="4.8497494168844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assionale!$B$161:$B$306</c:f>
              <c:strCache>
                <c:ptCount val="146"/>
                <c:pt idx="0">
                  <c:v>Acetone </c:v>
                </c:pt>
                <c:pt idx="1">
                  <c:v>Methyl acetate </c:v>
                </c:pt>
                <c:pt idx="2">
                  <c:v>Tetrahydrofuran </c:v>
                </c:pt>
                <c:pt idx="3">
                  <c:v>2-Methyl-furan</c:v>
                </c:pt>
                <c:pt idx="4">
                  <c:v> 2,4-Dimethyl-1-heptene</c:v>
                </c:pt>
                <c:pt idx="5">
                  <c:v>2-Butanone</c:v>
                </c:pt>
                <c:pt idx="6">
                  <c:v>2,3-Dihydro-5-methyl-Furane</c:v>
                </c:pt>
                <c:pt idx="7">
                  <c:v>2-Methyl butanal</c:v>
                </c:pt>
                <c:pt idx="8">
                  <c:v>3-Methyl butanal</c:v>
                </c:pt>
                <c:pt idx="9">
                  <c:v>2,5-dimethyl-furane</c:v>
                </c:pt>
                <c:pt idx="10">
                  <c:v>1-Methyl piperidine</c:v>
                </c:pt>
                <c:pt idx="11">
                  <c:v>Unknown 1</c:v>
                </c:pt>
                <c:pt idx="12">
                  <c:v>2,3-Butanedione </c:v>
                </c:pt>
                <c:pt idx="13">
                  <c:v>Methyl 3-methylbutanoate</c:v>
                </c:pt>
                <c:pt idx="14">
                  <c:v>Thiophene </c:v>
                </c:pt>
                <c:pt idx="15">
                  <c:v>N-Methyl-1,2,5,6-tetrahydropyridine</c:v>
                </c:pt>
                <c:pt idx="16">
                  <c:v>3-Hexanone</c:v>
                </c:pt>
                <c:pt idx="17">
                  <c:v>Unknown 2</c:v>
                </c:pt>
                <c:pt idx="18">
                  <c:v>2,3-Pentanedione </c:v>
                </c:pt>
                <c:pt idx="19">
                  <c:v>Dimethyl disulfide</c:v>
                </c:pt>
                <c:pt idx="20">
                  <c:v>4-Vinylfuran</c:v>
                </c:pt>
                <c:pt idx="21">
                  <c:v>Hexanal </c:v>
                </c:pt>
                <c:pt idx="22">
                  <c:v>Tridecanol</c:v>
                </c:pt>
                <c:pt idx="23">
                  <c:v>3,3,5-Trimethyl-1,5-heptadiene</c:v>
                </c:pt>
                <c:pt idx="24">
                  <c:v>4,5-Dimethyl-2-undecene </c:v>
                </c:pt>
                <c:pt idx="25">
                  <c:v>3-penten-2-one</c:v>
                </c:pt>
                <c:pt idx="26">
                  <c:v>2,3-Hexanedione </c:v>
                </c:pt>
                <c:pt idx="27">
                  <c:v>1-Methyl-1H-pyrrole </c:v>
                </c:pt>
                <c:pt idx="28">
                  <c:v>3,4-Hexandione</c:v>
                </c:pt>
                <c:pt idx="29">
                  <c:v>2-Vinyl-5-methylfuran</c:v>
                </c:pt>
                <c:pt idx="30">
                  <c:v>beta-Myrcene</c:v>
                </c:pt>
                <c:pt idx="31">
                  <c:v>Pyridine</c:v>
                </c:pt>
                <c:pt idx="32">
                  <c:v>Limonene</c:v>
                </c:pt>
                <c:pt idx="33">
                  <c:v>Pyrazine </c:v>
                </c:pt>
                <c:pt idx="34">
                  <c:v>Butyl butanoate</c:v>
                </c:pt>
                <c:pt idx="35">
                  <c:v>2-n-Pentylfuran</c:v>
                </c:pt>
                <c:pt idx="36">
                  <c:v>2-Furfuryl methyl ether</c:v>
                </c:pt>
                <c:pt idx="37">
                  <c:v>Thiazole</c:v>
                </c:pt>
                <c:pt idx="38">
                  <c:v>3-Methyl-3-buten-1-ol </c:v>
                </c:pt>
                <c:pt idx="39">
                  <c:v>E-beta Ocimene </c:v>
                </c:pt>
                <c:pt idx="40">
                  <c:v>3-Methyl-2-butenyl acetate</c:v>
                </c:pt>
                <c:pt idx="41">
                  <c:v>Methyl-pyrazine</c:v>
                </c:pt>
                <c:pt idx="42">
                  <c:v>Dihydro-2-methyl-3(2H)-furanone</c:v>
                </c:pt>
                <c:pt idx="43">
                  <c:v>2,5-Dimethyl-1H-pyrrole</c:v>
                </c:pt>
                <c:pt idx="44">
                  <c:v> 3-Hydroxy-2-butanone</c:v>
                </c:pt>
                <c:pt idx="45">
                  <c:v>trans-2-Methyl-5-n-propenylfuran</c:v>
                </c:pt>
                <c:pt idx="46">
                  <c:v>1-Hydroxy-2-propanone</c:v>
                </c:pt>
                <c:pt idx="47">
                  <c:v>2,5-Dimethyl-pyrazine</c:v>
                </c:pt>
                <c:pt idx="48">
                  <c:v>2,6-Dimethyl-pyrazine</c:v>
                </c:pt>
                <c:pt idx="49">
                  <c:v>2-Ethyl-pyrazine </c:v>
                </c:pt>
                <c:pt idx="50">
                  <c:v>2,3-Dimethyl-Pyrazine+2-Hydroxyisobutyric acid  </c:v>
                </c:pt>
                <c:pt idx="51">
                  <c:v>2-Cyclopenten-1-one </c:v>
                </c:pt>
                <c:pt idx="52">
                  <c:v>Unknown 3</c:v>
                </c:pt>
                <c:pt idx="53">
                  <c:v>2-Hydroxy-3-pentanone </c:v>
                </c:pt>
                <c:pt idx="54">
                  <c:v>2-Methyl-2-cyclopenten-1-one </c:v>
                </c:pt>
                <c:pt idx="55">
                  <c:v>2-Ethyl-6-methyl-Pyrazine</c:v>
                </c:pt>
                <c:pt idx="56">
                  <c:v>2-Ethyl-5-methyl-Pyrazine</c:v>
                </c:pt>
                <c:pt idx="57">
                  <c:v>2,3,5-Trimethyl-Pyrazine  </c:v>
                </c:pt>
                <c:pt idx="58">
                  <c:v>2-Ethyl-3-methylpyrazine</c:v>
                </c:pt>
                <c:pt idx="59">
                  <c:v>2-Methyl-3(2H)furanon</c:v>
                </c:pt>
                <c:pt idx="60">
                  <c:v>2-(n-propyl)-Pyrazine</c:v>
                </c:pt>
                <c:pt idx="61">
                  <c:v>2,6-diethyl-Pyrazine</c:v>
                </c:pt>
                <c:pt idx="62">
                  <c:v>2-Furfurylthiol</c:v>
                </c:pt>
                <c:pt idx="63">
                  <c:v>2-ethyl-3,5-dimethyl-Pyrazine</c:v>
                </c:pt>
                <c:pt idx="64">
                  <c:v>Acetic acid </c:v>
                </c:pt>
                <c:pt idx="65">
                  <c:v>2,3-Diethylpyrazine </c:v>
                </c:pt>
                <c:pt idx="66">
                  <c:v>Furfural </c:v>
                </c:pt>
                <c:pt idx="67">
                  <c:v>trans-Linalool oxide</c:v>
                </c:pt>
                <c:pt idx="68">
                  <c:v>Acetoxyacetone</c:v>
                </c:pt>
                <c:pt idx="69">
                  <c:v>2-Methyl-6-vinyl pyrazine</c:v>
                </c:pt>
                <c:pt idx="70">
                  <c:v>Furfuryl methyl sulfide</c:v>
                </c:pt>
                <c:pt idx="71">
                  <c:v>3,5-Diethyl-2-methyl-pyrazine</c:v>
                </c:pt>
                <c:pt idx="72">
                  <c:v>2,5-Dimethyl-3(2H)-furanone</c:v>
                </c:pt>
                <c:pt idx="73">
                  <c:v>2,5-Hexanedione </c:v>
                </c:pt>
                <c:pt idx="74">
                  <c:v>2-Acetylfuran</c:v>
                </c:pt>
                <c:pt idx="75">
                  <c:v>4-Vinyltetrahydro-2H-pyran-2-one</c:v>
                </c:pt>
                <c:pt idx="76">
                  <c:v>1-(2-Furyl)-2-propanone</c:v>
                </c:pt>
                <c:pt idx="77">
                  <c:v>2,3-Dimethyl-2-cyclopenten-1-one </c:v>
                </c:pt>
                <c:pt idx="78">
                  <c:v>2-oxopropyl propanoate</c:v>
                </c:pt>
                <c:pt idx="79">
                  <c:v>1-Acetoxy-2-butanone</c:v>
                </c:pt>
                <c:pt idx="80">
                  <c:v>Furfuryl acetate</c:v>
                </c:pt>
                <c:pt idx="81">
                  <c:v>Propanoic acid </c:v>
                </c:pt>
                <c:pt idx="82">
                  <c:v> 5-Methyl-2-furancarboxaldehyde</c:v>
                </c:pt>
                <c:pt idx="83">
                  <c:v>2-Propionylfuran</c:v>
                </c:pt>
                <c:pt idx="84">
                  <c:v>(5-Methyl-2-furyl)methanethiol</c:v>
                </c:pt>
                <c:pt idx="85">
                  <c:v>(1-methylethenyl)-Pyrazine</c:v>
                </c:pt>
                <c:pt idx="86">
                  <c:v>2-Acetylpyridine</c:v>
                </c:pt>
                <c:pt idx="87">
                  <c:v>Furfuryl propanoate</c:v>
                </c:pt>
                <c:pt idx="88">
                  <c:v>5H-5-Methyl-6,7-dihydrocyclopentapyrazine</c:v>
                </c:pt>
                <c:pt idx="89">
                  <c:v>1-methyl 1H-Pyrrole-2-carboxaldehyde</c:v>
                </c:pt>
                <c:pt idx="90">
                  <c:v>4-hydroxy-butanoic acid</c:v>
                </c:pt>
                <c:pt idx="91">
                  <c:v>2-Isopropenylpyrazine</c:v>
                </c:pt>
                <c:pt idx="92">
                  <c:v>Butanoic acid</c:v>
                </c:pt>
                <c:pt idx="93">
                  <c:v>2,5-dihydro-3,5-dimethyl-2-Furanone</c:v>
                </c:pt>
                <c:pt idx="94">
                  <c:v>1-(2-Furyl)-butan-3-one </c:v>
                </c:pt>
                <c:pt idx="95">
                  <c:v>2-Acetyl-1-methylpyrrole</c:v>
                </c:pt>
                <c:pt idx="96">
                  <c:v>3-Mercapto-3-methyl-1-butanol</c:v>
                </c:pt>
                <c:pt idx="97">
                  <c:v>Furfuryl alcohol</c:v>
                </c:pt>
                <c:pt idx="98">
                  <c:v>3-Ethyl-2-hydroxy-2-cyclopenten-1-one</c:v>
                </c:pt>
                <c:pt idx="99">
                  <c:v>3-Methyl-butanoic acid</c:v>
                </c:pt>
                <c:pt idx="100">
                  <c:v>2-Furfuryl-5-methylfuran</c:v>
                </c:pt>
                <c:pt idx="101">
                  <c:v>Acetyl-6-methylpyrazine</c:v>
                </c:pt>
                <c:pt idx="102">
                  <c:v>Unknown 4</c:v>
                </c:pt>
                <c:pt idx="103">
                  <c:v>Unknown 5</c:v>
                </c:pt>
                <c:pt idx="104">
                  <c:v>N-acetyl-4(H)-Pyridine</c:v>
                </c:pt>
                <c:pt idx="105">
                  <c:v>3-Methoxy-2-methyl-cyclohex-2-enone</c:v>
                </c:pt>
                <c:pt idx="106">
                  <c:v>3-ethyl-4-methyl-2,5-Furandione</c:v>
                </c:pt>
                <c:pt idx="107">
                  <c:v>2(5H)-Furanone</c:v>
                </c:pt>
                <c:pt idx="108">
                  <c:v>Methyl salicylate</c:v>
                </c:pt>
                <c:pt idx="109">
                  <c:v>Unknown 6</c:v>
                </c:pt>
                <c:pt idx="110">
                  <c:v>Unknown 7</c:v>
                </c:pt>
                <c:pt idx="111">
                  <c:v>3,5-DIMETHYL CYCLOPENTENOLONE</c:v>
                </c:pt>
                <c:pt idx="112">
                  <c:v>Unknown 8</c:v>
                </c:pt>
                <c:pt idx="113">
                  <c:v>3-methyl-2-Butenoic acid</c:v>
                </c:pt>
                <c:pt idx="114">
                  <c:v>Unknown 9</c:v>
                </c:pt>
                <c:pt idx="115">
                  <c:v>2-hydroxy-3-methyl-2-Cyclopenten-1-one </c:v>
                </c:pt>
                <c:pt idx="116">
                  <c:v>1-(2-furanylmethyl)-1H-Pyrrole </c:v>
                </c:pt>
                <c:pt idx="117">
                  <c:v>Unknown 10</c:v>
                </c:pt>
                <c:pt idx="118">
                  <c:v>n-butylbenzoate</c:v>
                </c:pt>
                <c:pt idx="119">
                  <c:v>2-methoxy-Phenol </c:v>
                </c:pt>
                <c:pt idx="120">
                  <c:v>Unknown 11</c:v>
                </c:pt>
                <c:pt idx="121">
                  <c:v>3-ethyl-2-hydroxy- 2-Cyclopenten-1-one</c:v>
                </c:pt>
                <c:pt idx="122">
                  <c:v>Unknown 12</c:v>
                </c:pt>
                <c:pt idx="123">
                  <c:v>Phenylethyl Alcohol </c:v>
                </c:pt>
                <c:pt idx="124">
                  <c:v>2-Thiophenemethanol</c:v>
                </c:pt>
                <c:pt idx="125">
                  <c:v>Maltol </c:v>
                </c:pt>
                <c:pt idx="126">
                  <c:v>2-Acetylpyrrole</c:v>
                </c:pt>
                <c:pt idx="127">
                  <c:v>4(1H)-Quinazolinone </c:v>
                </c:pt>
                <c:pt idx="128">
                  <c:v>Difurfuryl ether</c:v>
                </c:pt>
                <c:pt idx="129">
                  <c:v>4-Hydroxy-3-methylacetophenone</c:v>
                </c:pt>
                <c:pt idx="130">
                  <c:v>Phenol </c:v>
                </c:pt>
                <c:pt idx="131">
                  <c:v>1H-Pyrrole-2-carboxaldehyde</c:v>
                </c:pt>
                <c:pt idx="132">
                  <c:v>4-ethyl guaiacol</c:v>
                </c:pt>
                <c:pt idx="133">
                  <c:v>2,5-Dimethyl-4-hydroxy-3(2H)-furanone (Furaneol)</c:v>
                </c:pt>
                <c:pt idx="134">
                  <c:v>5-Acetyldihydro-2(3H)-furanone (Solerone)</c:v>
                </c:pt>
                <c:pt idx="135">
                  <c:v>N-Methyl-2-formylpyrrol</c:v>
                </c:pt>
                <c:pt idx="136">
                  <c:v>Unknown 13</c:v>
                </c:pt>
                <c:pt idx="137">
                  <c:v>Nonanoic acid </c:v>
                </c:pt>
                <c:pt idx="138">
                  <c:v>2-Vinyl guaiacol</c:v>
                </c:pt>
                <c:pt idx="139">
                  <c:v>Unknown 14</c:v>
                </c:pt>
                <c:pt idx="140">
                  <c:v>n-Decanoic acid </c:v>
                </c:pt>
                <c:pt idx="141">
                  <c:v>2-Benzofuran-1(3H)-one</c:v>
                </c:pt>
                <c:pt idx="142">
                  <c:v>2,3-dihydro-Benzofuran</c:v>
                </c:pt>
                <c:pt idx="143">
                  <c:v>Unknown 15</c:v>
                </c:pt>
                <c:pt idx="144">
                  <c:v>Indole</c:v>
                </c:pt>
                <c:pt idx="145">
                  <c:v>Benzoic acid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cat>
            <c:strRef>
              <c:f>Passionale!$B$161:$B$307</c:f>
              <c:strCache>
                <c:ptCount val="147"/>
                <c:pt idx="0">
                  <c:v>Acetone </c:v>
                </c:pt>
                <c:pt idx="1">
                  <c:v>Methyl acetate </c:v>
                </c:pt>
                <c:pt idx="2">
                  <c:v>Tetrahydrofuran </c:v>
                </c:pt>
                <c:pt idx="3">
                  <c:v>2-Methyl-furan</c:v>
                </c:pt>
                <c:pt idx="4">
                  <c:v> 2,4-Dimethyl-1-heptene</c:v>
                </c:pt>
                <c:pt idx="5">
                  <c:v>2-Butanone</c:v>
                </c:pt>
                <c:pt idx="6">
                  <c:v>2,3-Dihydro-5-methyl-Furane</c:v>
                </c:pt>
                <c:pt idx="7">
                  <c:v>2-Methyl butanal</c:v>
                </c:pt>
                <c:pt idx="8">
                  <c:v>3-Methyl butanal</c:v>
                </c:pt>
                <c:pt idx="9">
                  <c:v>2,5-dimethyl-furane</c:v>
                </c:pt>
                <c:pt idx="10">
                  <c:v>1-Methyl piperidine</c:v>
                </c:pt>
                <c:pt idx="11">
                  <c:v>Unknown 1</c:v>
                </c:pt>
                <c:pt idx="12">
                  <c:v>2,3-Butanedione </c:v>
                </c:pt>
                <c:pt idx="13">
                  <c:v>Methyl 3-methylbutanoate</c:v>
                </c:pt>
                <c:pt idx="14">
                  <c:v>Thiophene </c:v>
                </c:pt>
                <c:pt idx="15">
                  <c:v>N-Methyl-1,2,5,6-tetrahydropyridine</c:v>
                </c:pt>
                <c:pt idx="16">
                  <c:v>3-Hexanone</c:v>
                </c:pt>
                <c:pt idx="17">
                  <c:v>Unknown 2</c:v>
                </c:pt>
                <c:pt idx="18">
                  <c:v>2,3-Pentanedione </c:v>
                </c:pt>
                <c:pt idx="19">
                  <c:v>Dimethyl disulfide</c:v>
                </c:pt>
                <c:pt idx="20">
                  <c:v>4-Vinylfuran</c:v>
                </c:pt>
                <c:pt idx="21">
                  <c:v>Hexanal </c:v>
                </c:pt>
                <c:pt idx="22">
                  <c:v>Tridecanol</c:v>
                </c:pt>
                <c:pt idx="23">
                  <c:v>3,3,5-Trimethyl-1,5-heptadiene</c:v>
                </c:pt>
                <c:pt idx="24">
                  <c:v>4,5-Dimethyl-2-undecene </c:v>
                </c:pt>
                <c:pt idx="25">
                  <c:v>3-penten-2-one</c:v>
                </c:pt>
                <c:pt idx="26">
                  <c:v>2,3-Hexanedione </c:v>
                </c:pt>
                <c:pt idx="27">
                  <c:v>1-Methyl-1H-pyrrole </c:v>
                </c:pt>
                <c:pt idx="28">
                  <c:v>3,4-Hexandione</c:v>
                </c:pt>
                <c:pt idx="29">
                  <c:v>2-Vinyl-5-methylfuran</c:v>
                </c:pt>
                <c:pt idx="30">
                  <c:v>beta-Myrcene</c:v>
                </c:pt>
                <c:pt idx="31">
                  <c:v>Pyridine</c:v>
                </c:pt>
                <c:pt idx="32">
                  <c:v>Limonene</c:v>
                </c:pt>
                <c:pt idx="33">
                  <c:v>Pyrazine </c:v>
                </c:pt>
                <c:pt idx="34">
                  <c:v>Butyl butanoate</c:v>
                </c:pt>
                <c:pt idx="35">
                  <c:v>2-n-Pentylfuran</c:v>
                </c:pt>
                <c:pt idx="36">
                  <c:v>2-Furfuryl methyl ether</c:v>
                </c:pt>
                <c:pt idx="37">
                  <c:v>Thiazole</c:v>
                </c:pt>
                <c:pt idx="38">
                  <c:v>3-Methyl-3-buten-1-ol </c:v>
                </c:pt>
                <c:pt idx="39">
                  <c:v>E-beta Ocimene </c:v>
                </c:pt>
                <c:pt idx="40">
                  <c:v>3-Methyl-2-butenyl acetate</c:v>
                </c:pt>
                <c:pt idx="41">
                  <c:v>Methyl-pyrazine</c:v>
                </c:pt>
                <c:pt idx="42">
                  <c:v>Dihydro-2-methyl-3(2H)-furanone</c:v>
                </c:pt>
                <c:pt idx="43">
                  <c:v>2,5-Dimethyl-1H-pyrrole</c:v>
                </c:pt>
                <c:pt idx="44">
                  <c:v> 3-Hydroxy-2-butanone</c:v>
                </c:pt>
                <c:pt idx="45">
                  <c:v>trans-2-Methyl-5-n-propenylfuran</c:v>
                </c:pt>
                <c:pt idx="46">
                  <c:v>1-Hydroxy-2-propanone</c:v>
                </c:pt>
                <c:pt idx="47">
                  <c:v>2,5-Dimethyl-pyrazine</c:v>
                </c:pt>
                <c:pt idx="48">
                  <c:v>2,6-Dimethyl-pyrazine</c:v>
                </c:pt>
                <c:pt idx="49">
                  <c:v>2-Ethyl-pyrazine </c:v>
                </c:pt>
                <c:pt idx="50">
                  <c:v>2,3-Dimethyl-Pyrazine+2-Hydroxyisobutyric acid  </c:v>
                </c:pt>
                <c:pt idx="51">
                  <c:v>2-Cyclopenten-1-one </c:v>
                </c:pt>
                <c:pt idx="52">
                  <c:v>Unknown 3</c:v>
                </c:pt>
                <c:pt idx="53">
                  <c:v>2-Hydroxy-3-pentanone </c:v>
                </c:pt>
                <c:pt idx="54">
                  <c:v>2-Methyl-2-cyclopenten-1-one </c:v>
                </c:pt>
                <c:pt idx="55">
                  <c:v>2-Ethyl-6-methyl-Pyrazine</c:v>
                </c:pt>
                <c:pt idx="56">
                  <c:v>2-Ethyl-5-methyl-Pyrazine</c:v>
                </c:pt>
                <c:pt idx="57">
                  <c:v>2,3,5-Trimethyl-Pyrazine  </c:v>
                </c:pt>
                <c:pt idx="58">
                  <c:v>2-Ethyl-3-methylpyrazine</c:v>
                </c:pt>
                <c:pt idx="59">
                  <c:v>2-Methyl-3(2H)furanon</c:v>
                </c:pt>
                <c:pt idx="60">
                  <c:v>2-(n-propyl)-Pyrazine</c:v>
                </c:pt>
                <c:pt idx="61">
                  <c:v>2,6-diethyl-Pyrazine</c:v>
                </c:pt>
                <c:pt idx="62">
                  <c:v>2-Furfurylthiol</c:v>
                </c:pt>
                <c:pt idx="63">
                  <c:v>2-ethyl-3,5-dimethyl-Pyrazine</c:v>
                </c:pt>
                <c:pt idx="64">
                  <c:v>Acetic acid </c:v>
                </c:pt>
                <c:pt idx="65">
                  <c:v>2,3-Diethylpyrazine </c:v>
                </c:pt>
                <c:pt idx="66">
                  <c:v>Furfural </c:v>
                </c:pt>
                <c:pt idx="67">
                  <c:v>trans-Linalool oxide</c:v>
                </c:pt>
                <c:pt idx="68">
                  <c:v>Acetoxyacetone</c:v>
                </c:pt>
                <c:pt idx="69">
                  <c:v>2-Methyl-6-vinyl pyrazine</c:v>
                </c:pt>
                <c:pt idx="70">
                  <c:v>Furfuryl methyl sulfide</c:v>
                </c:pt>
                <c:pt idx="71">
                  <c:v>3,5-Diethyl-2-methyl-pyrazine</c:v>
                </c:pt>
                <c:pt idx="72">
                  <c:v>2,5-Dimethyl-3(2H)-furanone</c:v>
                </c:pt>
                <c:pt idx="73">
                  <c:v>2,5-Hexanedione </c:v>
                </c:pt>
                <c:pt idx="74">
                  <c:v>2-Acetylfuran</c:v>
                </c:pt>
                <c:pt idx="75">
                  <c:v>4-Vinyltetrahydro-2H-pyran-2-one</c:v>
                </c:pt>
                <c:pt idx="76">
                  <c:v>1-(2-Furyl)-2-propanone</c:v>
                </c:pt>
                <c:pt idx="77">
                  <c:v>2,3-Dimethyl-2-cyclopenten-1-one </c:v>
                </c:pt>
                <c:pt idx="78">
                  <c:v>2-oxopropyl propanoate</c:v>
                </c:pt>
                <c:pt idx="79">
                  <c:v>1-Acetoxy-2-butanone</c:v>
                </c:pt>
                <c:pt idx="80">
                  <c:v>Furfuryl acetate</c:v>
                </c:pt>
                <c:pt idx="81">
                  <c:v>Propanoic acid </c:v>
                </c:pt>
                <c:pt idx="82">
                  <c:v> 5-Methyl-2-furancarboxaldehyde</c:v>
                </c:pt>
                <c:pt idx="83">
                  <c:v>2-Propionylfuran</c:v>
                </c:pt>
                <c:pt idx="84">
                  <c:v>(5-Methyl-2-furyl)methanethiol</c:v>
                </c:pt>
                <c:pt idx="85">
                  <c:v>(1-methylethenyl)-Pyrazine</c:v>
                </c:pt>
                <c:pt idx="86">
                  <c:v>2-Acetylpyridine</c:v>
                </c:pt>
                <c:pt idx="87">
                  <c:v>Furfuryl propanoate</c:v>
                </c:pt>
                <c:pt idx="88">
                  <c:v>5H-5-Methyl-6,7-dihydrocyclopentapyrazine</c:v>
                </c:pt>
                <c:pt idx="89">
                  <c:v>1-methyl 1H-Pyrrole-2-carboxaldehyde</c:v>
                </c:pt>
                <c:pt idx="90">
                  <c:v>4-hydroxy-butanoic acid</c:v>
                </c:pt>
                <c:pt idx="91">
                  <c:v>2-Isopropenylpyrazine</c:v>
                </c:pt>
                <c:pt idx="92">
                  <c:v>Butanoic acid</c:v>
                </c:pt>
                <c:pt idx="93">
                  <c:v>2,5-dihydro-3,5-dimethyl-2-Furanone</c:v>
                </c:pt>
                <c:pt idx="94">
                  <c:v>1-(2-Furyl)-butan-3-one </c:v>
                </c:pt>
                <c:pt idx="95">
                  <c:v>2-Acetyl-1-methylpyrrole</c:v>
                </c:pt>
                <c:pt idx="96">
                  <c:v>3-Mercapto-3-methyl-1-butanol</c:v>
                </c:pt>
                <c:pt idx="97">
                  <c:v>Furfuryl alcohol</c:v>
                </c:pt>
                <c:pt idx="98">
                  <c:v>3-Ethyl-2-hydroxy-2-cyclopenten-1-one</c:v>
                </c:pt>
                <c:pt idx="99">
                  <c:v>3-Methyl-butanoic acid</c:v>
                </c:pt>
                <c:pt idx="100">
                  <c:v>2-Furfuryl-5-methylfuran</c:v>
                </c:pt>
                <c:pt idx="101">
                  <c:v>Acetyl-6-methylpyrazine</c:v>
                </c:pt>
                <c:pt idx="102">
                  <c:v>Unknown 4</c:v>
                </c:pt>
                <c:pt idx="103">
                  <c:v>Unknown 5</c:v>
                </c:pt>
                <c:pt idx="104">
                  <c:v>N-acetyl-4(H)-Pyridine</c:v>
                </c:pt>
                <c:pt idx="105">
                  <c:v>3-Methoxy-2-methyl-cyclohex-2-enone</c:v>
                </c:pt>
                <c:pt idx="106">
                  <c:v>3-ethyl-4-methyl-2,5-Furandione</c:v>
                </c:pt>
                <c:pt idx="107">
                  <c:v>2(5H)-Furanone</c:v>
                </c:pt>
                <c:pt idx="108">
                  <c:v>Methyl salicylate</c:v>
                </c:pt>
                <c:pt idx="109">
                  <c:v>Unknown 6</c:v>
                </c:pt>
                <c:pt idx="110">
                  <c:v>Unknown 7</c:v>
                </c:pt>
                <c:pt idx="111">
                  <c:v>3,5-DIMETHYL CYCLOPENTENOLONE</c:v>
                </c:pt>
                <c:pt idx="112">
                  <c:v>Unknown 8</c:v>
                </c:pt>
                <c:pt idx="113">
                  <c:v>3-methyl-2-Butenoic acid</c:v>
                </c:pt>
                <c:pt idx="114">
                  <c:v>Unknown 9</c:v>
                </c:pt>
                <c:pt idx="115">
                  <c:v>2-hydroxy-3-methyl-2-Cyclopenten-1-one </c:v>
                </c:pt>
                <c:pt idx="116">
                  <c:v>1-(2-furanylmethyl)-1H-Pyrrole </c:v>
                </c:pt>
                <c:pt idx="117">
                  <c:v>Unknown 10</c:v>
                </c:pt>
                <c:pt idx="118">
                  <c:v>n-butylbenzoate</c:v>
                </c:pt>
                <c:pt idx="119">
                  <c:v>2-methoxy-Phenol </c:v>
                </c:pt>
                <c:pt idx="120">
                  <c:v>Unknown 11</c:v>
                </c:pt>
                <c:pt idx="121">
                  <c:v>3-ethyl-2-hydroxy- 2-Cyclopenten-1-one</c:v>
                </c:pt>
                <c:pt idx="122">
                  <c:v>Unknown 12</c:v>
                </c:pt>
                <c:pt idx="123">
                  <c:v>Phenylethyl Alcohol </c:v>
                </c:pt>
                <c:pt idx="124">
                  <c:v>2-Thiophenemethanol</c:v>
                </c:pt>
                <c:pt idx="125">
                  <c:v>Maltol </c:v>
                </c:pt>
                <c:pt idx="126">
                  <c:v>2-Acetylpyrrole</c:v>
                </c:pt>
                <c:pt idx="127">
                  <c:v>4(1H)-Quinazolinone </c:v>
                </c:pt>
                <c:pt idx="128">
                  <c:v>Difurfuryl ether</c:v>
                </c:pt>
                <c:pt idx="129">
                  <c:v>4-Hydroxy-3-methylacetophenone</c:v>
                </c:pt>
                <c:pt idx="130">
                  <c:v>Phenol </c:v>
                </c:pt>
                <c:pt idx="131">
                  <c:v>1H-Pyrrole-2-carboxaldehyde</c:v>
                </c:pt>
                <c:pt idx="132">
                  <c:v>4-ethyl guaiacol</c:v>
                </c:pt>
                <c:pt idx="133">
                  <c:v>2,5-Dimethyl-4-hydroxy-3(2H)-furanone (Furaneol)</c:v>
                </c:pt>
                <c:pt idx="134">
                  <c:v>5-Acetyldihydro-2(3H)-furanone (Solerone)</c:v>
                </c:pt>
                <c:pt idx="135">
                  <c:v>N-Methyl-2-formylpyrrol</c:v>
                </c:pt>
                <c:pt idx="136">
                  <c:v>Unknown 13</c:v>
                </c:pt>
                <c:pt idx="137">
                  <c:v>Nonanoic acid </c:v>
                </c:pt>
                <c:pt idx="138">
                  <c:v>2-Vinyl guaiacol</c:v>
                </c:pt>
                <c:pt idx="139">
                  <c:v>Unknown 14</c:v>
                </c:pt>
                <c:pt idx="140">
                  <c:v>n-Decanoic acid </c:v>
                </c:pt>
                <c:pt idx="141">
                  <c:v>2-Benzofuran-1(3H)-one</c:v>
                </c:pt>
                <c:pt idx="142">
                  <c:v>2,3-dihydro-Benzofuran</c:v>
                </c:pt>
                <c:pt idx="143">
                  <c:v>Unknown 15</c:v>
                </c:pt>
                <c:pt idx="144">
                  <c:v>Indole</c:v>
                </c:pt>
                <c:pt idx="145">
                  <c:v>Benzoic acid</c:v>
                </c:pt>
                <c:pt idx="146">
                  <c:v>5-(Hydroxymethyl)dihydro-2(3H)-furanone</c:v>
                </c:pt>
              </c:strCache>
            </c:strRef>
          </c:cat>
          <c:val>
            <c:numRef>
              <c:f>Passionale!$N$161:$N$307</c:f>
              <c:numCache>
                <c:formatCode>0.0</c:formatCode>
                <c:ptCount val="147"/>
                <c:pt idx="0">
                  <c:v>98.391899149536016</c:v>
                </c:pt>
                <c:pt idx="1">
                  <c:v>103.4047904230632</c:v>
                </c:pt>
                <c:pt idx="2">
                  <c:v>-9.1941731422732484</c:v>
                </c:pt>
                <c:pt idx="3">
                  <c:v>61.601906006733898</c:v>
                </c:pt>
                <c:pt idx="4">
                  <c:v>0</c:v>
                </c:pt>
                <c:pt idx="5">
                  <c:v>111.98350024709292</c:v>
                </c:pt>
                <c:pt idx="6">
                  <c:v>22.362295081967211</c:v>
                </c:pt>
                <c:pt idx="7">
                  <c:v>22.487220755883158</c:v>
                </c:pt>
                <c:pt idx="8">
                  <c:v>-21.753835968205067</c:v>
                </c:pt>
                <c:pt idx="9">
                  <c:v>14.550609903287365</c:v>
                </c:pt>
                <c:pt idx="10">
                  <c:v>-95.874565981826009</c:v>
                </c:pt>
                <c:pt idx="11">
                  <c:v>31.858163826278197</c:v>
                </c:pt>
                <c:pt idx="12">
                  <c:v>-59.221730719662155</c:v>
                </c:pt>
                <c:pt idx="13">
                  <c:v>-8.8211630676149593</c:v>
                </c:pt>
                <c:pt idx="14">
                  <c:v>-52.005415709119404</c:v>
                </c:pt>
                <c:pt idx="15">
                  <c:v>-95.168560436825601</c:v>
                </c:pt>
                <c:pt idx="16">
                  <c:v>-2.1830336331987659</c:v>
                </c:pt>
                <c:pt idx="17">
                  <c:v>-10.895788202455751</c:v>
                </c:pt>
                <c:pt idx="18">
                  <c:v>-43.105076843808682</c:v>
                </c:pt>
                <c:pt idx="19">
                  <c:v>171.93577521324636</c:v>
                </c:pt>
                <c:pt idx="20">
                  <c:v>-29.466858789625366</c:v>
                </c:pt>
                <c:pt idx="21">
                  <c:v>-54.608899165350778</c:v>
                </c:pt>
                <c:pt idx="22">
                  <c:v>0</c:v>
                </c:pt>
                <c:pt idx="23">
                  <c:v>0</c:v>
                </c:pt>
                <c:pt idx="24">
                  <c:v>-30.635608241896016</c:v>
                </c:pt>
                <c:pt idx="25">
                  <c:v>-77.153726895884418</c:v>
                </c:pt>
                <c:pt idx="26">
                  <c:v>-45.315261582947244</c:v>
                </c:pt>
                <c:pt idx="27">
                  <c:v>-15.681830074116975</c:v>
                </c:pt>
                <c:pt idx="28">
                  <c:v>-33.449426460070498</c:v>
                </c:pt>
                <c:pt idx="29">
                  <c:v>-33.07287170323972</c:v>
                </c:pt>
                <c:pt idx="30">
                  <c:v>-39.942433795257642</c:v>
                </c:pt>
                <c:pt idx="31">
                  <c:v>9.052549202916877</c:v>
                </c:pt>
                <c:pt idx="32">
                  <c:v>-45.300894049707239</c:v>
                </c:pt>
                <c:pt idx="33">
                  <c:v>37.489322482736739</c:v>
                </c:pt>
                <c:pt idx="34">
                  <c:v>-48.614796361740332</c:v>
                </c:pt>
                <c:pt idx="35">
                  <c:v>-63.846793053023219</c:v>
                </c:pt>
                <c:pt idx="36">
                  <c:v>-1.6356474697757983</c:v>
                </c:pt>
                <c:pt idx="37">
                  <c:v>36.271840715156415</c:v>
                </c:pt>
                <c:pt idx="38">
                  <c:v>-2.8313074701247216</c:v>
                </c:pt>
                <c:pt idx="39">
                  <c:v>-38.520262457684971</c:v>
                </c:pt>
                <c:pt idx="40">
                  <c:v>-11.959784408541854</c:v>
                </c:pt>
                <c:pt idx="41">
                  <c:v>8.1760357220643733</c:v>
                </c:pt>
                <c:pt idx="42">
                  <c:v>19.124898084496479</c:v>
                </c:pt>
                <c:pt idx="43">
                  <c:v>-91.862492806876759</c:v>
                </c:pt>
                <c:pt idx="44">
                  <c:v>50.301486748611659</c:v>
                </c:pt>
                <c:pt idx="45">
                  <c:v>-18.271727144060364</c:v>
                </c:pt>
                <c:pt idx="46">
                  <c:v>0.13689388510749487</c:v>
                </c:pt>
                <c:pt idx="47">
                  <c:v>-12.901033725770644</c:v>
                </c:pt>
                <c:pt idx="48">
                  <c:v>-14.930015694979435</c:v>
                </c:pt>
                <c:pt idx="49">
                  <c:v>-6.4746378132800331</c:v>
                </c:pt>
                <c:pt idx="50">
                  <c:v>-19.289449736244986</c:v>
                </c:pt>
                <c:pt idx="51">
                  <c:v>-72.193861975048634</c:v>
                </c:pt>
                <c:pt idx="52">
                  <c:v>-3.1524134108593658</c:v>
                </c:pt>
                <c:pt idx="53">
                  <c:v>17.09951036564803</c:v>
                </c:pt>
                <c:pt idx="54">
                  <c:v>10.574204964619664</c:v>
                </c:pt>
                <c:pt idx="55">
                  <c:v>-18.960060177941312</c:v>
                </c:pt>
                <c:pt idx="56">
                  <c:v>-18.267505085774552</c:v>
                </c:pt>
                <c:pt idx="57">
                  <c:v>-3.5659346329728239</c:v>
                </c:pt>
                <c:pt idx="58">
                  <c:v>-16.075131271161244</c:v>
                </c:pt>
                <c:pt idx="59">
                  <c:v>-71.725685834419622</c:v>
                </c:pt>
                <c:pt idx="60">
                  <c:v>-22.85581555150749</c:v>
                </c:pt>
                <c:pt idx="61">
                  <c:v>-23.365165991601014</c:v>
                </c:pt>
                <c:pt idx="62">
                  <c:v>-100</c:v>
                </c:pt>
                <c:pt idx="63">
                  <c:v>-21.699469912738429</c:v>
                </c:pt>
                <c:pt idx="64">
                  <c:v>115.19561062600478</c:v>
                </c:pt>
                <c:pt idx="65">
                  <c:v>-20.515844479601139</c:v>
                </c:pt>
                <c:pt idx="66">
                  <c:v>-35.335054267045834</c:v>
                </c:pt>
                <c:pt idx="67">
                  <c:v>-43.715822544918929</c:v>
                </c:pt>
                <c:pt idx="68">
                  <c:v>7.7052055625906082</c:v>
                </c:pt>
                <c:pt idx="69">
                  <c:v>-66.566422745508632</c:v>
                </c:pt>
                <c:pt idx="70">
                  <c:v>-20.65872648149389</c:v>
                </c:pt>
                <c:pt idx="71">
                  <c:v>-19.181094125384725</c:v>
                </c:pt>
                <c:pt idx="72">
                  <c:v>-31.053183038678426</c:v>
                </c:pt>
                <c:pt idx="73">
                  <c:v>2.5898484233670862</c:v>
                </c:pt>
                <c:pt idx="74">
                  <c:v>16.784415484677425</c:v>
                </c:pt>
                <c:pt idx="75">
                  <c:v>-82.923041504703519</c:v>
                </c:pt>
                <c:pt idx="76">
                  <c:v>-2.1644047701106368</c:v>
                </c:pt>
                <c:pt idx="77">
                  <c:v>-14.352809471168996</c:v>
                </c:pt>
                <c:pt idx="78">
                  <c:v>-9.3247168233726203</c:v>
                </c:pt>
                <c:pt idx="79">
                  <c:v>-7.7493874667077565</c:v>
                </c:pt>
                <c:pt idx="80">
                  <c:v>-6.4580627288226458</c:v>
                </c:pt>
                <c:pt idx="81">
                  <c:v>94.901180511775436</c:v>
                </c:pt>
                <c:pt idx="82">
                  <c:v>-8.435451205089759</c:v>
                </c:pt>
                <c:pt idx="83">
                  <c:v>-2.0736033812167571</c:v>
                </c:pt>
                <c:pt idx="84">
                  <c:v>-9.7185972124405282</c:v>
                </c:pt>
                <c:pt idx="85">
                  <c:v>-19.663222165713762</c:v>
                </c:pt>
                <c:pt idx="86">
                  <c:v>-10.464958841478357</c:v>
                </c:pt>
                <c:pt idx="87">
                  <c:v>-11.952341026433078</c:v>
                </c:pt>
                <c:pt idx="88">
                  <c:v>-23.557173103619853</c:v>
                </c:pt>
                <c:pt idx="89">
                  <c:v>-1.0949222639760052</c:v>
                </c:pt>
                <c:pt idx="90">
                  <c:v>33.111314413041789</c:v>
                </c:pt>
                <c:pt idx="91">
                  <c:v>-24.543690594623495</c:v>
                </c:pt>
                <c:pt idx="92">
                  <c:v>0</c:v>
                </c:pt>
                <c:pt idx="93">
                  <c:v>7.6585866404266998</c:v>
                </c:pt>
                <c:pt idx="94">
                  <c:v>-13.480091088238208</c:v>
                </c:pt>
                <c:pt idx="95">
                  <c:v>-16.896833898124783</c:v>
                </c:pt>
                <c:pt idx="96">
                  <c:v>-61.474636869992338</c:v>
                </c:pt>
                <c:pt idx="97">
                  <c:v>20.495161217608317</c:v>
                </c:pt>
                <c:pt idx="98">
                  <c:v>-17.233406061266631</c:v>
                </c:pt>
                <c:pt idx="99">
                  <c:v>3.6007130414236954</c:v>
                </c:pt>
                <c:pt idx="100">
                  <c:v>0</c:v>
                </c:pt>
                <c:pt idx="101">
                  <c:v>-17.256018442250205</c:v>
                </c:pt>
                <c:pt idx="102">
                  <c:v>-22.059707559178086</c:v>
                </c:pt>
                <c:pt idx="103">
                  <c:v>-8.6577260802030178</c:v>
                </c:pt>
                <c:pt idx="104">
                  <c:v>-15.763450551711061</c:v>
                </c:pt>
                <c:pt idx="105">
                  <c:v>-22.155013305149904</c:v>
                </c:pt>
                <c:pt idx="106">
                  <c:v>-30.170204144079321</c:v>
                </c:pt>
                <c:pt idx="107">
                  <c:v>0</c:v>
                </c:pt>
                <c:pt idx="108">
                  <c:v>0</c:v>
                </c:pt>
                <c:pt idx="109">
                  <c:v>-35.840510730879416</c:v>
                </c:pt>
                <c:pt idx="110">
                  <c:v>-63.802911746473256</c:v>
                </c:pt>
                <c:pt idx="111">
                  <c:v>-13.056331739355889</c:v>
                </c:pt>
                <c:pt idx="112">
                  <c:v>-18.381232484042496</c:v>
                </c:pt>
                <c:pt idx="113">
                  <c:v>0</c:v>
                </c:pt>
                <c:pt idx="114">
                  <c:v>-9.2515979859167103</c:v>
                </c:pt>
                <c:pt idx="115">
                  <c:v>3.0445054583378148</c:v>
                </c:pt>
                <c:pt idx="116">
                  <c:v>-16.434253043704608</c:v>
                </c:pt>
                <c:pt idx="117">
                  <c:v>-1.8880561073986983</c:v>
                </c:pt>
                <c:pt idx="118">
                  <c:v>-14.190847763862205</c:v>
                </c:pt>
                <c:pt idx="119">
                  <c:v>-14.358377586409931</c:v>
                </c:pt>
                <c:pt idx="120">
                  <c:v>-22.413300209462147</c:v>
                </c:pt>
                <c:pt idx="121">
                  <c:v>-11.38504230047789</c:v>
                </c:pt>
                <c:pt idx="122">
                  <c:v>-32.124436742028792</c:v>
                </c:pt>
                <c:pt idx="123">
                  <c:v>-16.251431340150788</c:v>
                </c:pt>
                <c:pt idx="124">
                  <c:v>7.9109391726571996</c:v>
                </c:pt>
                <c:pt idx="125">
                  <c:v>-1.5533011005002211</c:v>
                </c:pt>
                <c:pt idx="126">
                  <c:v>16.672911448073492</c:v>
                </c:pt>
                <c:pt idx="127">
                  <c:v>-7.8000885721762518</c:v>
                </c:pt>
                <c:pt idx="128">
                  <c:v>-9.8312755609179217</c:v>
                </c:pt>
                <c:pt idx="129">
                  <c:v>-12.09541726926885</c:v>
                </c:pt>
                <c:pt idx="130">
                  <c:v>15.418545622269821</c:v>
                </c:pt>
                <c:pt idx="131">
                  <c:v>46.087737608457992</c:v>
                </c:pt>
                <c:pt idx="132">
                  <c:v>-18.786334768034056</c:v>
                </c:pt>
                <c:pt idx="133">
                  <c:v>-27.837931817679323</c:v>
                </c:pt>
                <c:pt idx="134">
                  <c:v>-18.136306254042712</c:v>
                </c:pt>
                <c:pt idx="135">
                  <c:v>34.81935009292453</c:v>
                </c:pt>
                <c:pt idx="136">
                  <c:v>-21.411421654193678</c:v>
                </c:pt>
                <c:pt idx="137">
                  <c:v>89.288088034696699</c:v>
                </c:pt>
                <c:pt idx="138">
                  <c:v>-47.966496378209676</c:v>
                </c:pt>
                <c:pt idx="139">
                  <c:v>-25.327995789444874</c:v>
                </c:pt>
                <c:pt idx="140">
                  <c:v>70.723724870536103</c:v>
                </c:pt>
                <c:pt idx="141">
                  <c:v>-30.51532936102382</c:v>
                </c:pt>
                <c:pt idx="142">
                  <c:v>-55.803287710723396</c:v>
                </c:pt>
                <c:pt idx="143">
                  <c:v>0</c:v>
                </c:pt>
                <c:pt idx="144">
                  <c:v>-20.450032206248284</c:v>
                </c:pt>
                <c:pt idx="145">
                  <c:v>0</c:v>
                </c:pt>
                <c:pt idx="146">
                  <c:v>25.4295568045094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8C-4196-AC30-5673B83051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197118719"/>
        <c:axId val="1197117471"/>
      </c:barChart>
      <c:catAx>
        <c:axId val="1197118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97117471"/>
        <c:crosses val="autoZero"/>
        <c:auto val="1"/>
        <c:lblAlgn val="ctr"/>
        <c:lblOffset val="100"/>
        <c:noMultiLvlLbl val="0"/>
      </c:catAx>
      <c:valAx>
        <c:axId val="1197117471"/>
        <c:scaling>
          <c:orientation val="minMax"/>
          <c:max val="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accent1">
                <a:alpha val="99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197118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dirty="0" smtClean="0"/>
              <a:t>CV% </a:t>
            </a:r>
            <a:r>
              <a:rPr lang="it-IT" sz="1200" dirty="0" err="1" smtClean="0"/>
              <a:t>between</a:t>
            </a:r>
            <a:r>
              <a:rPr lang="it-IT" sz="1200" dirty="0" smtClean="0"/>
              <a:t> </a:t>
            </a:r>
            <a:r>
              <a:rPr lang="it-IT" sz="1200" dirty="0" err="1"/>
              <a:t>good</a:t>
            </a:r>
            <a:r>
              <a:rPr lang="it-IT" sz="1200" dirty="0"/>
              <a:t> </a:t>
            </a:r>
            <a:r>
              <a:rPr lang="it-IT" sz="1200" i="1" dirty="0"/>
              <a:t>vs</a:t>
            </a:r>
            <a:r>
              <a:rPr lang="it-IT" sz="1200" dirty="0"/>
              <a:t> </a:t>
            </a:r>
            <a:r>
              <a:rPr lang="it-IT" sz="1200" smtClean="0"/>
              <a:t>oxidised</a:t>
            </a:r>
            <a:r>
              <a:rPr lang="it-IT" sz="1200" dirty="0" smtClean="0"/>
              <a:t> </a:t>
            </a:r>
            <a:r>
              <a:rPr lang="it-IT" sz="1200" dirty="0"/>
              <a:t>(I) </a:t>
            </a:r>
          </a:p>
        </c:rich>
      </c:tx>
      <c:layout>
        <c:manualLayout>
          <c:xMode val="edge"/>
          <c:yMode val="edge"/>
          <c:x val="0.24230363801947577"/>
          <c:y val="5.33472435857290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cat>
            <c:strRef>
              <c:f>Bio!$B$161:$B$307</c:f>
              <c:strCache>
                <c:ptCount val="147"/>
                <c:pt idx="0">
                  <c:v>Acetone </c:v>
                </c:pt>
                <c:pt idx="1">
                  <c:v>Methyl acetate </c:v>
                </c:pt>
                <c:pt idx="2">
                  <c:v>Tetrahydrofuran </c:v>
                </c:pt>
                <c:pt idx="3">
                  <c:v>2-Methyl-furan</c:v>
                </c:pt>
                <c:pt idx="4">
                  <c:v> 2,4-Dimethyl-1-heptene</c:v>
                </c:pt>
                <c:pt idx="5">
                  <c:v>2-Butanone</c:v>
                </c:pt>
                <c:pt idx="6">
                  <c:v>2,3-Dihydro-5-methyl-Furane</c:v>
                </c:pt>
                <c:pt idx="7">
                  <c:v>2-Methyl butanal</c:v>
                </c:pt>
                <c:pt idx="8">
                  <c:v>3-Methyl butanal</c:v>
                </c:pt>
                <c:pt idx="9">
                  <c:v>2,5-dimethyl-furane</c:v>
                </c:pt>
                <c:pt idx="10">
                  <c:v>1-Methyl piperidine</c:v>
                </c:pt>
                <c:pt idx="11">
                  <c:v>Unknown 1</c:v>
                </c:pt>
                <c:pt idx="12">
                  <c:v>2,3-Butanedione </c:v>
                </c:pt>
                <c:pt idx="13">
                  <c:v>Methyl 3-methylbutanoate</c:v>
                </c:pt>
                <c:pt idx="14">
                  <c:v>Thiophene </c:v>
                </c:pt>
                <c:pt idx="15">
                  <c:v>N-Methyl-1,2,5,6-tetrahydropyridine</c:v>
                </c:pt>
                <c:pt idx="16">
                  <c:v>3-Hexanone</c:v>
                </c:pt>
                <c:pt idx="17">
                  <c:v>Unknown 2</c:v>
                </c:pt>
                <c:pt idx="18">
                  <c:v>2,3-Pentanedione </c:v>
                </c:pt>
                <c:pt idx="19">
                  <c:v>Dimethyl disulfide</c:v>
                </c:pt>
                <c:pt idx="20">
                  <c:v>4-Vinylfuran</c:v>
                </c:pt>
                <c:pt idx="21">
                  <c:v>Hexanal </c:v>
                </c:pt>
                <c:pt idx="22">
                  <c:v>Tridecanol</c:v>
                </c:pt>
                <c:pt idx="23">
                  <c:v>3,3,5-Trimethyl-1,5-heptadiene</c:v>
                </c:pt>
                <c:pt idx="24">
                  <c:v>4,5-Dimethyl-2-undecene </c:v>
                </c:pt>
                <c:pt idx="25">
                  <c:v>3-penten-2-one</c:v>
                </c:pt>
                <c:pt idx="26">
                  <c:v>2,3-Hexanedione </c:v>
                </c:pt>
                <c:pt idx="27">
                  <c:v>1-Methyl-1H-pyrrole </c:v>
                </c:pt>
                <c:pt idx="28">
                  <c:v>3,4-Hexandione</c:v>
                </c:pt>
                <c:pt idx="29">
                  <c:v>2-Vinyl-5-methylfuran</c:v>
                </c:pt>
                <c:pt idx="30">
                  <c:v>beta-Myrcene</c:v>
                </c:pt>
                <c:pt idx="31">
                  <c:v>Pyridine</c:v>
                </c:pt>
                <c:pt idx="32">
                  <c:v>Limonene</c:v>
                </c:pt>
                <c:pt idx="33">
                  <c:v>Pyrazine </c:v>
                </c:pt>
                <c:pt idx="34">
                  <c:v>Butyl butanoate</c:v>
                </c:pt>
                <c:pt idx="35">
                  <c:v>2-n-Pentylfuran</c:v>
                </c:pt>
                <c:pt idx="36">
                  <c:v>2-Furfuryl methyl ether</c:v>
                </c:pt>
                <c:pt idx="37">
                  <c:v>Thiazole</c:v>
                </c:pt>
                <c:pt idx="38">
                  <c:v>3-Methyl-3-buten-1-ol </c:v>
                </c:pt>
                <c:pt idx="39">
                  <c:v>E-beta Ocimene </c:v>
                </c:pt>
                <c:pt idx="40">
                  <c:v>3-Methyl-2-butenyl acetate</c:v>
                </c:pt>
                <c:pt idx="41">
                  <c:v>Methyl-pyrazine</c:v>
                </c:pt>
                <c:pt idx="42">
                  <c:v>Dihydro-2-methyl-3(2H)-furanone</c:v>
                </c:pt>
                <c:pt idx="43">
                  <c:v>2,5-Dimethyl-1H-pyrrole</c:v>
                </c:pt>
                <c:pt idx="44">
                  <c:v> 3-Hydroxy-2-butanone</c:v>
                </c:pt>
                <c:pt idx="45">
                  <c:v>trans-2-Methyl-5-n-propenylfuran</c:v>
                </c:pt>
                <c:pt idx="46">
                  <c:v>1-Hydroxy-2-propanone</c:v>
                </c:pt>
                <c:pt idx="47">
                  <c:v>2,5-Dimethyl-pyrazine</c:v>
                </c:pt>
                <c:pt idx="48">
                  <c:v>2,6-Dimethyl-pyrazine</c:v>
                </c:pt>
                <c:pt idx="49">
                  <c:v>2-Ethyl-pyrazine </c:v>
                </c:pt>
                <c:pt idx="50">
                  <c:v>2,3-Dimethyl-Pyrazine+2-Hydroxyisobutyric acid  </c:v>
                </c:pt>
                <c:pt idx="51">
                  <c:v>2-Cyclopenten-1-one </c:v>
                </c:pt>
                <c:pt idx="52">
                  <c:v>Unknown 3</c:v>
                </c:pt>
                <c:pt idx="53">
                  <c:v>2-Hydroxy-3-pentanone </c:v>
                </c:pt>
                <c:pt idx="54">
                  <c:v>2-Methyl-2-cyclopenten-1-one </c:v>
                </c:pt>
                <c:pt idx="55">
                  <c:v>2-Ethyl-6-methyl-Pyrazine</c:v>
                </c:pt>
                <c:pt idx="56">
                  <c:v>2-Ethyl-5-methyl-Pyrazine</c:v>
                </c:pt>
                <c:pt idx="57">
                  <c:v>2,3,5-Trimethyl-Pyrazine  </c:v>
                </c:pt>
                <c:pt idx="58">
                  <c:v>2-Ethyl-3-methylpyrazine</c:v>
                </c:pt>
                <c:pt idx="59">
                  <c:v>2-Methyl-3(2H)furanon</c:v>
                </c:pt>
                <c:pt idx="60">
                  <c:v>2-(n-propyl)-Pyrazine</c:v>
                </c:pt>
                <c:pt idx="61">
                  <c:v>2,6-diethyl-Pyrazine</c:v>
                </c:pt>
                <c:pt idx="62">
                  <c:v>2-Furfurylthiol</c:v>
                </c:pt>
                <c:pt idx="63">
                  <c:v>2-ethyl-3,5-dimethyl-Pyrazine</c:v>
                </c:pt>
                <c:pt idx="64">
                  <c:v>Acetic acid </c:v>
                </c:pt>
                <c:pt idx="65">
                  <c:v>2,3-Diethylpyrazine </c:v>
                </c:pt>
                <c:pt idx="66">
                  <c:v>Furfural </c:v>
                </c:pt>
                <c:pt idx="67">
                  <c:v>trans-Linalool oxide</c:v>
                </c:pt>
                <c:pt idx="68">
                  <c:v>Acetoxyacetone</c:v>
                </c:pt>
                <c:pt idx="69">
                  <c:v>2-Methyl-6-vinyl pyrazine</c:v>
                </c:pt>
                <c:pt idx="70">
                  <c:v>Furfuryl methyl sulfide</c:v>
                </c:pt>
                <c:pt idx="71">
                  <c:v>3,5-Diethyl-2-methyl-pyrazine</c:v>
                </c:pt>
                <c:pt idx="72">
                  <c:v>2,5-Dimethyl-3(2H)-furanone</c:v>
                </c:pt>
                <c:pt idx="73">
                  <c:v>2,5-Hexanedione </c:v>
                </c:pt>
                <c:pt idx="74">
                  <c:v>2-Acetylfuran</c:v>
                </c:pt>
                <c:pt idx="75">
                  <c:v>4-Vinyltetrahydro-2H-pyran-2-one</c:v>
                </c:pt>
                <c:pt idx="76">
                  <c:v>1-(2-Furyl)-2-propanone</c:v>
                </c:pt>
                <c:pt idx="77">
                  <c:v>2,3-Dimethyl-2-cyclopenten-1-one </c:v>
                </c:pt>
                <c:pt idx="78">
                  <c:v>2-oxopropyl propanoate</c:v>
                </c:pt>
                <c:pt idx="79">
                  <c:v>1-Acetoxy-2-butanone</c:v>
                </c:pt>
                <c:pt idx="80">
                  <c:v>Furfuryl acetate</c:v>
                </c:pt>
                <c:pt idx="81">
                  <c:v>Propanoic acid </c:v>
                </c:pt>
                <c:pt idx="82">
                  <c:v> 5-Methyl-2-furancarboxaldehyde</c:v>
                </c:pt>
                <c:pt idx="83">
                  <c:v>2-Propionylfuran</c:v>
                </c:pt>
                <c:pt idx="84">
                  <c:v>(5-Methyl-2-furyl)methanethiol</c:v>
                </c:pt>
                <c:pt idx="85">
                  <c:v>(1-methylethenyl)-Pyrazine</c:v>
                </c:pt>
                <c:pt idx="86">
                  <c:v>2-Acetylpyridine</c:v>
                </c:pt>
                <c:pt idx="87">
                  <c:v>Furfuryl propanoate</c:v>
                </c:pt>
                <c:pt idx="88">
                  <c:v>5H-5-Methyl-6,7-dihydrocyclopentapyrazine</c:v>
                </c:pt>
                <c:pt idx="89">
                  <c:v>1-methyl 1H-Pyrrole-2-carboxaldehyde</c:v>
                </c:pt>
                <c:pt idx="90">
                  <c:v>4-hydroxy-butanoic acid</c:v>
                </c:pt>
                <c:pt idx="91">
                  <c:v>2-Isopropenylpyrazine</c:v>
                </c:pt>
                <c:pt idx="92">
                  <c:v>Butanoic acid</c:v>
                </c:pt>
                <c:pt idx="93">
                  <c:v>2,5-dihydro-3,5-dimethyl-2-Furanone</c:v>
                </c:pt>
                <c:pt idx="94">
                  <c:v>1-(2-Furyl)-butan-3-one </c:v>
                </c:pt>
                <c:pt idx="95">
                  <c:v>2-Acetyl-1-methylpyrrole</c:v>
                </c:pt>
                <c:pt idx="96">
                  <c:v>3-Mercapto-3-methyl-1-butanol</c:v>
                </c:pt>
                <c:pt idx="97">
                  <c:v>Furfuryl alcohol</c:v>
                </c:pt>
                <c:pt idx="98">
                  <c:v>3-Ethyl-2-hydroxy-2-cyclopenten-1-one</c:v>
                </c:pt>
                <c:pt idx="99">
                  <c:v>3-Methyl-butanoic acid</c:v>
                </c:pt>
                <c:pt idx="100">
                  <c:v>2-Furfuryl-5-methylfuran</c:v>
                </c:pt>
                <c:pt idx="101">
                  <c:v>Acetyl-6-methylpyrazine</c:v>
                </c:pt>
                <c:pt idx="102">
                  <c:v>Unknown 4</c:v>
                </c:pt>
                <c:pt idx="103">
                  <c:v>Unknown 5</c:v>
                </c:pt>
                <c:pt idx="104">
                  <c:v>N-acetyl-4(H)-Pyridine</c:v>
                </c:pt>
                <c:pt idx="105">
                  <c:v>3-Methoxy-2-methyl-cyclohex-2-enone</c:v>
                </c:pt>
                <c:pt idx="106">
                  <c:v>3-ethyl-4-methyl-2,5-Furandione</c:v>
                </c:pt>
                <c:pt idx="107">
                  <c:v>2(5H)-Furanone</c:v>
                </c:pt>
                <c:pt idx="108">
                  <c:v>Methyl salicylate</c:v>
                </c:pt>
                <c:pt idx="109">
                  <c:v>Unknown 6</c:v>
                </c:pt>
                <c:pt idx="110">
                  <c:v>Unknown 7</c:v>
                </c:pt>
                <c:pt idx="111">
                  <c:v>3,5-DIMETHYL CYCLOPENTENOLONE</c:v>
                </c:pt>
                <c:pt idx="112">
                  <c:v>Unknown 8</c:v>
                </c:pt>
                <c:pt idx="113">
                  <c:v>3-methyl-2-Butenoic acid</c:v>
                </c:pt>
                <c:pt idx="114">
                  <c:v>Unknown 9</c:v>
                </c:pt>
                <c:pt idx="115">
                  <c:v>2-hydroxy-3-methyl-2-Cyclopenten-1-one </c:v>
                </c:pt>
                <c:pt idx="116">
                  <c:v>1-(2-furanylmethyl)-1H-Pyrrole </c:v>
                </c:pt>
                <c:pt idx="117">
                  <c:v>Unknown 10</c:v>
                </c:pt>
                <c:pt idx="118">
                  <c:v>n-butylbenzoate</c:v>
                </c:pt>
                <c:pt idx="119">
                  <c:v>2-methoxy-Phenol </c:v>
                </c:pt>
                <c:pt idx="120">
                  <c:v>Unknown 11</c:v>
                </c:pt>
                <c:pt idx="121">
                  <c:v>3-ethyl-2-hydroxy- 2-Cyclopenten-1-one</c:v>
                </c:pt>
                <c:pt idx="122">
                  <c:v>Unknown 12</c:v>
                </c:pt>
                <c:pt idx="123">
                  <c:v>Phenylethyl Alcohol </c:v>
                </c:pt>
                <c:pt idx="124">
                  <c:v>2-Thiophenemethanol</c:v>
                </c:pt>
                <c:pt idx="125">
                  <c:v>Maltol </c:v>
                </c:pt>
                <c:pt idx="126">
                  <c:v>2-Acetylpyrrole</c:v>
                </c:pt>
                <c:pt idx="127">
                  <c:v>4(1H)-Quinazolinone </c:v>
                </c:pt>
                <c:pt idx="128">
                  <c:v>Difurfuryl ether</c:v>
                </c:pt>
                <c:pt idx="129">
                  <c:v>4-Hydroxy-3-methylacetophenone</c:v>
                </c:pt>
                <c:pt idx="130">
                  <c:v>Phenol </c:v>
                </c:pt>
                <c:pt idx="131">
                  <c:v>1H-Pyrrole-2-carboxaldehyde</c:v>
                </c:pt>
                <c:pt idx="132">
                  <c:v>4-ethyl guaiacol</c:v>
                </c:pt>
                <c:pt idx="133">
                  <c:v>2,5-Dimethyl-4-hydroxy-3(2H)-furanone (Furaneol)</c:v>
                </c:pt>
                <c:pt idx="134">
                  <c:v>5-Acetyldihydro-2(3H)-furanone (Solerone)</c:v>
                </c:pt>
                <c:pt idx="135">
                  <c:v>N-Methyl-2-formylpyrrol</c:v>
                </c:pt>
                <c:pt idx="136">
                  <c:v>Unknown 13</c:v>
                </c:pt>
                <c:pt idx="137">
                  <c:v>Nonanoic acid </c:v>
                </c:pt>
                <c:pt idx="138">
                  <c:v>2-Vinyl guaiacol</c:v>
                </c:pt>
                <c:pt idx="139">
                  <c:v>Unknown 14</c:v>
                </c:pt>
                <c:pt idx="140">
                  <c:v>n-Decanoic acid </c:v>
                </c:pt>
                <c:pt idx="141">
                  <c:v>2-Benzofuran-1(3H)-one</c:v>
                </c:pt>
                <c:pt idx="142">
                  <c:v>2,3-dihydro-Benzofuran</c:v>
                </c:pt>
                <c:pt idx="143">
                  <c:v>Unknown 15</c:v>
                </c:pt>
                <c:pt idx="144">
                  <c:v>Indole</c:v>
                </c:pt>
                <c:pt idx="145">
                  <c:v>Benzoic acid</c:v>
                </c:pt>
                <c:pt idx="146">
                  <c:v>5-(Hydroxymethyl)dihydro-2(3H)-furanone</c:v>
                </c:pt>
              </c:strCache>
            </c:strRef>
          </c:cat>
          <c:val>
            <c:numRef>
              <c:f>Intenso!$P$160:$P$306</c:f>
              <c:numCache>
                <c:formatCode>0.0</c:formatCode>
                <c:ptCount val="147"/>
                <c:pt idx="0">
                  <c:v>-44.68927905923082</c:v>
                </c:pt>
                <c:pt idx="1">
                  <c:v>-59.665698601676162</c:v>
                </c:pt>
                <c:pt idx="2">
                  <c:v>40.886809118922208</c:v>
                </c:pt>
                <c:pt idx="3">
                  <c:v>-52.877433975346854</c:v>
                </c:pt>
                <c:pt idx="4">
                  <c:v>0</c:v>
                </c:pt>
                <c:pt idx="5">
                  <c:v>-11.231656463189609</c:v>
                </c:pt>
                <c:pt idx="6">
                  <c:v>5.749799856739588</c:v>
                </c:pt>
                <c:pt idx="7">
                  <c:v>-11.140148475390369</c:v>
                </c:pt>
                <c:pt idx="8">
                  <c:v>-57.250139103327044</c:v>
                </c:pt>
                <c:pt idx="9">
                  <c:v>-36.444559689792882</c:v>
                </c:pt>
                <c:pt idx="10">
                  <c:v>-90.856769741130478</c:v>
                </c:pt>
                <c:pt idx="11">
                  <c:v>-15.128954249817342</c:v>
                </c:pt>
                <c:pt idx="12">
                  <c:v>-74.927273613862411</c:v>
                </c:pt>
                <c:pt idx="13">
                  <c:v>-22.555395228400318</c:v>
                </c:pt>
                <c:pt idx="14">
                  <c:v>-56.382019029463336</c:v>
                </c:pt>
                <c:pt idx="15">
                  <c:v>-85.105538961400541</c:v>
                </c:pt>
                <c:pt idx="16">
                  <c:v>-22.279624268058875</c:v>
                </c:pt>
                <c:pt idx="17">
                  <c:v>-42.108671019262935</c:v>
                </c:pt>
                <c:pt idx="18">
                  <c:v>-79.917150812099223</c:v>
                </c:pt>
                <c:pt idx="19">
                  <c:v>42.796271454298228</c:v>
                </c:pt>
                <c:pt idx="20">
                  <c:v>-86.080894541851109</c:v>
                </c:pt>
                <c:pt idx="21">
                  <c:v>-3.6747513253644359</c:v>
                </c:pt>
                <c:pt idx="22">
                  <c:v>0</c:v>
                </c:pt>
                <c:pt idx="23">
                  <c:v>0</c:v>
                </c:pt>
                <c:pt idx="24">
                  <c:v>-10.969935228988186</c:v>
                </c:pt>
                <c:pt idx="25">
                  <c:v>-82.32461759089999</c:v>
                </c:pt>
                <c:pt idx="26">
                  <c:v>-81.163574725434671</c:v>
                </c:pt>
                <c:pt idx="27">
                  <c:v>-86.769962617119063</c:v>
                </c:pt>
                <c:pt idx="28">
                  <c:v>-75.838088858395835</c:v>
                </c:pt>
                <c:pt idx="29">
                  <c:v>-81.11255236318901</c:v>
                </c:pt>
                <c:pt idx="30">
                  <c:v>-25.971801137910106</c:v>
                </c:pt>
                <c:pt idx="31">
                  <c:v>-29.825279828819717</c:v>
                </c:pt>
                <c:pt idx="32">
                  <c:v>-9.5725578733659251</c:v>
                </c:pt>
                <c:pt idx="33">
                  <c:v>-25.816575455837302</c:v>
                </c:pt>
                <c:pt idx="34">
                  <c:v>82.24081435771194</c:v>
                </c:pt>
                <c:pt idx="35">
                  <c:v>95.692082256285289</c:v>
                </c:pt>
                <c:pt idx="36">
                  <c:v>-25.914714204366085</c:v>
                </c:pt>
                <c:pt idx="37">
                  <c:v>-4.7213702103396651</c:v>
                </c:pt>
                <c:pt idx="38">
                  <c:v>-45.645276917679709</c:v>
                </c:pt>
                <c:pt idx="39">
                  <c:v>-25.829225036687813</c:v>
                </c:pt>
                <c:pt idx="40">
                  <c:v>22.331518389151448</c:v>
                </c:pt>
                <c:pt idx="41">
                  <c:v>-26.968508971205967</c:v>
                </c:pt>
                <c:pt idx="42">
                  <c:v>-27.587712388882629</c:v>
                </c:pt>
                <c:pt idx="43">
                  <c:v>-100</c:v>
                </c:pt>
                <c:pt idx="44">
                  <c:v>1.9901326172512759</c:v>
                </c:pt>
                <c:pt idx="45">
                  <c:v>-27.639222658377527</c:v>
                </c:pt>
                <c:pt idx="46">
                  <c:v>-43.671759479981972</c:v>
                </c:pt>
                <c:pt idx="47">
                  <c:v>-36.527474371461331</c:v>
                </c:pt>
                <c:pt idx="48">
                  <c:v>-35.934360174923228</c:v>
                </c:pt>
                <c:pt idx="49">
                  <c:v>-36.849094714023373</c:v>
                </c:pt>
                <c:pt idx="50">
                  <c:v>-35.152079391720605</c:v>
                </c:pt>
                <c:pt idx="51">
                  <c:v>-80.483713753328018</c:v>
                </c:pt>
                <c:pt idx="52">
                  <c:v>-35.783019635936149</c:v>
                </c:pt>
                <c:pt idx="53">
                  <c:v>-19.207379098767589</c:v>
                </c:pt>
                <c:pt idx="54">
                  <c:v>-29.85995982740025</c:v>
                </c:pt>
                <c:pt idx="55">
                  <c:v>-26.227669498355656</c:v>
                </c:pt>
                <c:pt idx="56">
                  <c:v>-26.700423223876456</c:v>
                </c:pt>
                <c:pt idx="57">
                  <c:v>-11.808645905285085</c:v>
                </c:pt>
                <c:pt idx="58">
                  <c:v>-20.588756306548994</c:v>
                </c:pt>
                <c:pt idx="59">
                  <c:v>-86.790167307234782</c:v>
                </c:pt>
                <c:pt idx="60">
                  <c:v>-34.600707715363939</c:v>
                </c:pt>
                <c:pt idx="61">
                  <c:v>-19.235893103721647</c:v>
                </c:pt>
                <c:pt idx="62">
                  <c:v>-100</c:v>
                </c:pt>
                <c:pt idx="63">
                  <c:v>-18.976026442807051</c:v>
                </c:pt>
                <c:pt idx="64">
                  <c:v>93.877393902000122</c:v>
                </c:pt>
                <c:pt idx="65">
                  <c:v>-17.030253631874189</c:v>
                </c:pt>
                <c:pt idx="66">
                  <c:v>-64.125234679920908</c:v>
                </c:pt>
                <c:pt idx="67">
                  <c:v>-36.598031453509975</c:v>
                </c:pt>
                <c:pt idx="68">
                  <c:v>-43.389939726763174</c:v>
                </c:pt>
                <c:pt idx="69">
                  <c:v>-76.99075679060752</c:v>
                </c:pt>
                <c:pt idx="70">
                  <c:v>-58.076220558950766</c:v>
                </c:pt>
                <c:pt idx="71">
                  <c:v>-21.629080866598681</c:v>
                </c:pt>
                <c:pt idx="72">
                  <c:v>-64.876322183720532</c:v>
                </c:pt>
                <c:pt idx="73">
                  <c:v>-48.777198976903499</c:v>
                </c:pt>
                <c:pt idx="74">
                  <c:v>-17.417408200510426</c:v>
                </c:pt>
                <c:pt idx="75">
                  <c:v>-97.509178488647734</c:v>
                </c:pt>
                <c:pt idx="76">
                  <c:v>-51.565160790256513</c:v>
                </c:pt>
                <c:pt idx="77">
                  <c:v>-35.059197214839557</c:v>
                </c:pt>
                <c:pt idx="78">
                  <c:v>-41.398753799036541</c:v>
                </c:pt>
                <c:pt idx="79">
                  <c:v>-41.964321106328299</c:v>
                </c:pt>
                <c:pt idx="80">
                  <c:v>-34.680099590447668</c:v>
                </c:pt>
                <c:pt idx="81">
                  <c:v>112.31894507053519</c:v>
                </c:pt>
                <c:pt idx="82">
                  <c:v>-47.872734407050942</c:v>
                </c:pt>
                <c:pt idx="83">
                  <c:v>-22.460919476093487</c:v>
                </c:pt>
                <c:pt idx="84">
                  <c:v>-58.883532499845835</c:v>
                </c:pt>
                <c:pt idx="85">
                  <c:v>-42.358344200526773</c:v>
                </c:pt>
                <c:pt idx="86">
                  <c:v>-32.110144898469677</c:v>
                </c:pt>
                <c:pt idx="87">
                  <c:v>-27.675754426167607</c:v>
                </c:pt>
                <c:pt idx="88">
                  <c:v>-31.821904170972903</c:v>
                </c:pt>
                <c:pt idx="89">
                  <c:v>-25.056061990688139</c:v>
                </c:pt>
                <c:pt idx="90">
                  <c:v>5.893943334263783</c:v>
                </c:pt>
                <c:pt idx="91">
                  <c:v>-39.468478275906484</c:v>
                </c:pt>
                <c:pt idx="92">
                  <c:v>0</c:v>
                </c:pt>
                <c:pt idx="93">
                  <c:v>-27.885902226002912</c:v>
                </c:pt>
                <c:pt idx="94">
                  <c:v>-38.617034389251806</c:v>
                </c:pt>
                <c:pt idx="95">
                  <c:v>-37.121517652619019</c:v>
                </c:pt>
                <c:pt idx="96">
                  <c:v>-94.04688988922257</c:v>
                </c:pt>
                <c:pt idx="97">
                  <c:v>-20.4807461388666</c:v>
                </c:pt>
                <c:pt idx="98">
                  <c:v>-29.107861250122891</c:v>
                </c:pt>
                <c:pt idx="99">
                  <c:v>8.9440002945020947</c:v>
                </c:pt>
                <c:pt idx="100">
                  <c:v>0</c:v>
                </c:pt>
                <c:pt idx="101">
                  <c:v>-37.221425647318476</c:v>
                </c:pt>
                <c:pt idx="102">
                  <c:v>-39.755974059891059</c:v>
                </c:pt>
                <c:pt idx="103">
                  <c:v>-32.176249844906913</c:v>
                </c:pt>
                <c:pt idx="104">
                  <c:v>-48.107860751647131</c:v>
                </c:pt>
                <c:pt idx="105">
                  <c:v>-42.052374913693193</c:v>
                </c:pt>
                <c:pt idx="106">
                  <c:v>-55.118028778840987</c:v>
                </c:pt>
                <c:pt idx="107">
                  <c:v>0</c:v>
                </c:pt>
                <c:pt idx="108">
                  <c:v>0</c:v>
                </c:pt>
                <c:pt idx="109">
                  <c:v>-56.573811320016731</c:v>
                </c:pt>
                <c:pt idx="110">
                  <c:v>-93.553105382068807</c:v>
                </c:pt>
                <c:pt idx="111">
                  <c:v>-23.879409597695247</c:v>
                </c:pt>
                <c:pt idx="112">
                  <c:v>-48.511713424506524</c:v>
                </c:pt>
                <c:pt idx="113">
                  <c:v>0</c:v>
                </c:pt>
                <c:pt idx="114">
                  <c:v>-22.082383260006605</c:v>
                </c:pt>
                <c:pt idx="115">
                  <c:v>-14.577117662914857</c:v>
                </c:pt>
                <c:pt idx="116">
                  <c:v>-43.717252637712853</c:v>
                </c:pt>
                <c:pt idx="117">
                  <c:v>-26.201367404375986</c:v>
                </c:pt>
                <c:pt idx="118">
                  <c:v>-6.9651820068522312</c:v>
                </c:pt>
                <c:pt idx="119">
                  <c:v>-37.37476311508685</c:v>
                </c:pt>
                <c:pt idx="120">
                  <c:v>-54.183155553926419</c:v>
                </c:pt>
                <c:pt idx="121">
                  <c:v>-32.63296855539263</c:v>
                </c:pt>
                <c:pt idx="122">
                  <c:v>-75.801878617725563</c:v>
                </c:pt>
                <c:pt idx="123">
                  <c:v>-53.707605368013702</c:v>
                </c:pt>
                <c:pt idx="124">
                  <c:v>-24.9648979010014</c:v>
                </c:pt>
                <c:pt idx="125">
                  <c:v>3.4169027227750823</c:v>
                </c:pt>
                <c:pt idx="126">
                  <c:v>-12.837072044570544</c:v>
                </c:pt>
                <c:pt idx="127">
                  <c:v>-44.993975316076508</c:v>
                </c:pt>
                <c:pt idx="128">
                  <c:v>-44.568870219645532</c:v>
                </c:pt>
                <c:pt idx="129">
                  <c:v>-45.442214388947534</c:v>
                </c:pt>
                <c:pt idx="130">
                  <c:v>-10.375351562687147</c:v>
                </c:pt>
                <c:pt idx="131">
                  <c:v>20.857781357872138</c:v>
                </c:pt>
                <c:pt idx="132">
                  <c:v>-42.208403777324776</c:v>
                </c:pt>
                <c:pt idx="133">
                  <c:v>-79.862550962200984</c:v>
                </c:pt>
                <c:pt idx="134">
                  <c:v>-39.779667404602826</c:v>
                </c:pt>
                <c:pt idx="135">
                  <c:v>-10.276849268450592</c:v>
                </c:pt>
                <c:pt idx="136">
                  <c:v>-54.195379002837448</c:v>
                </c:pt>
                <c:pt idx="137">
                  <c:v>-16.568751968741083</c:v>
                </c:pt>
                <c:pt idx="138">
                  <c:v>-77.211413211324938</c:v>
                </c:pt>
                <c:pt idx="139">
                  <c:v>-31.642717340276803</c:v>
                </c:pt>
                <c:pt idx="140">
                  <c:v>-38.973865597729606</c:v>
                </c:pt>
                <c:pt idx="141">
                  <c:v>2.5940746315934482</c:v>
                </c:pt>
                <c:pt idx="142">
                  <c:v>-75.807364872966602</c:v>
                </c:pt>
                <c:pt idx="143">
                  <c:v>0</c:v>
                </c:pt>
                <c:pt idx="144">
                  <c:v>-57.891415167972951</c:v>
                </c:pt>
                <c:pt idx="145">
                  <c:v>0</c:v>
                </c:pt>
                <c:pt idx="146">
                  <c:v>47.2551615433206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8A-41F2-BFAD-51A6925318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197118719"/>
        <c:axId val="1197117471"/>
      </c:barChart>
      <c:catAx>
        <c:axId val="11971187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b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197117471"/>
        <c:crosses val="autoZero"/>
        <c:auto val="1"/>
        <c:lblAlgn val="ctr"/>
        <c:lblOffset val="100"/>
        <c:noMultiLvlLbl val="0"/>
      </c:catAx>
      <c:valAx>
        <c:axId val="11971174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197118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cap="none" spc="2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it-IT" sz="1200" b="0" i="0" u="none" strike="noStrike" cap="none" baseline="0" dirty="0" smtClean="0">
                <a:effectLst/>
              </a:rPr>
              <a:t>CV% </a:t>
            </a:r>
            <a:r>
              <a:rPr lang="it-IT" sz="1200" b="0" i="0" u="none" strike="noStrike" cap="none" baseline="0" dirty="0" err="1" smtClean="0">
                <a:effectLst/>
              </a:rPr>
              <a:t>between</a:t>
            </a:r>
            <a:r>
              <a:rPr lang="it-IT" sz="1200" b="0" i="0" u="none" strike="noStrike" cap="none" baseline="0" dirty="0" smtClean="0">
                <a:effectLst/>
              </a:rPr>
              <a:t> </a:t>
            </a:r>
            <a:r>
              <a:rPr lang="it-IT" sz="1200" b="0" i="0" u="none" strike="noStrike" cap="none" baseline="0" dirty="0" err="1">
                <a:effectLst/>
              </a:rPr>
              <a:t>good</a:t>
            </a:r>
            <a:r>
              <a:rPr lang="it-IT" sz="1200" b="0" i="0" u="none" strike="noStrike" cap="none" baseline="0" dirty="0">
                <a:effectLst/>
              </a:rPr>
              <a:t> </a:t>
            </a:r>
            <a:r>
              <a:rPr lang="it-IT" sz="1200" b="0" i="1" u="none" strike="noStrike" cap="none" baseline="0" dirty="0">
                <a:effectLst/>
              </a:rPr>
              <a:t>vs</a:t>
            </a:r>
            <a:r>
              <a:rPr lang="it-IT" sz="1200" b="0" i="0" u="none" strike="noStrike" cap="none" baseline="0" dirty="0">
                <a:effectLst/>
              </a:rPr>
              <a:t> </a:t>
            </a:r>
            <a:r>
              <a:rPr lang="it-IT" sz="1200" b="0" i="0" u="none" strike="noStrike" cap="none" baseline="0" dirty="0" err="1" smtClean="0">
                <a:effectLst/>
              </a:rPr>
              <a:t>oxidised</a:t>
            </a:r>
            <a:r>
              <a:rPr lang="it-IT" sz="1200" b="0" i="0" u="none" strike="noStrike" cap="none" baseline="0" dirty="0" smtClean="0">
                <a:effectLst/>
              </a:rPr>
              <a:t> </a:t>
            </a:r>
            <a:r>
              <a:rPr lang="en-GB" sz="1200" dirty="0"/>
              <a:t>(M)</a:t>
            </a:r>
          </a:p>
        </c:rich>
      </c:tx>
      <c:layout>
        <c:manualLayout>
          <c:xMode val="edge"/>
          <c:yMode val="edge"/>
          <c:x val="0.23304822199908068"/>
          <c:y val="5.81704478093902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cat>
            <c:strRef>
              <c:f>Bio!$B$161:$B$307</c:f>
              <c:strCache>
                <c:ptCount val="147"/>
                <c:pt idx="0">
                  <c:v>Acetone </c:v>
                </c:pt>
                <c:pt idx="1">
                  <c:v>Methyl acetate </c:v>
                </c:pt>
                <c:pt idx="2">
                  <c:v>Tetrahydrofuran </c:v>
                </c:pt>
                <c:pt idx="3">
                  <c:v>2-Methyl-furan</c:v>
                </c:pt>
                <c:pt idx="4">
                  <c:v> 2,4-Dimethyl-1-heptene</c:v>
                </c:pt>
                <c:pt idx="5">
                  <c:v>2-Butanone</c:v>
                </c:pt>
                <c:pt idx="6">
                  <c:v>2,3-Dihydro-5-methyl-Furane</c:v>
                </c:pt>
                <c:pt idx="7">
                  <c:v>2-Methyl butanal</c:v>
                </c:pt>
                <c:pt idx="8">
                  <c:v>3-Methyl butanal</c:v>
                </c:pt>
                <c:pt idx="9">
                  <c:v>2,5-dimethyl-furane</c:v>
                </c:pt>
                <c:pt idx="10">
                  <c:v>1-Methyl piperidine</c:v>
                </c:pt>
                <c:pt idx="11">
                  <c:v>Unknown 1</c:v>
                </c:pt>
                <c:pt idx="12">
                  <c:v>2,3-Butanedione </c:v>
                </c:pt>
                <c:pt idx="13">
                  <c:v>Methyl 3-methylbutanoate</c:v>
                </c:pt>
                <c:pt idx="14">
                  <c:v>Thiophene </c:v>
                </c:pt>
                <c:pt idx="15">
                  <c:v>N-Methyl-1,2,5,6-tetrahydropyridine</c:v>
                </c:pt>
                <c:pt idx="16">
                  <c:v>3-Hexanone</c:v>
                </c:pt>
                <c:pt idx="17">
                  <c:v>Unknown 2</c:v>
                </c:pt>
                <c:pt idx="18">
                  <c:v>2,3-Pentanedione </c:v>
                </c:pt>
                <c:pt idx="19">
                  <c:v>Dimethyl disulfide</c:v>
                </c:pt>
                <c:pt idx="20">
                  <c:v>4-Vinylfuran</c:v>
                </c:pt>
                <c:pt idx="21">
                  <c:v>Hexanal </c:v>
                </c:pt>
                <c:pt idx="22">
                  <c:v>Tridecanol</c:v>
                </c:pt>
                <c:pt idx="23">
                  <c:v>3,3,5-Trimethyl-1,5-heptadiene</c:v>
                </c:pt>
                <c:pt idx="24">
                  <c:v>4,5-Dimethyl-2-undecene </c:v>
                </c:pt>
                <c:pt idx="25">
                  <c:v>3-penten-2-one</c:v>
                </c:pt>
                <c:pt idx="26">
                  <c:v>2,3-Hexanedione </c:v>
                </c:pt>
                <c:pt idx="27">
                  <c:v>1-Methyl-1H-pyrrole </c:v>
                </c:pt>
                <c:pt idx="28">
                  <c:v>3,4-Hexandione</c:v>
                </c:pt>
                <c:pt idx="29">
                  <c:v>2-Vinyl-5-methylfuran</c:v>
                </c:pt>
                <c:pt idx="30">
                  <c:v>beta-Myrcene</c:v>
                </c:pt>
                <c:pt idx="31">
                  <c:v>Pyridine</c:v>
                </c:pt>
                <c:pt idx="32">
                  <c:v>Limonene</c:v>
                </c:pt>
                <c:pt idx="33">
                  <c:v>Pyrazine </c:v>
                </c:pt>
                <c:pt idx="34">
                  <c:v>Butyl butanoate</c:v>
                </c:pt>
                <c:pt idx="35">
                  <c:v>2-n-Pentylfuran</c:v>
                </c:pt>
                <c:pt idx="36">
                  <c:v>2-Furfuryl methyl ether</c:v>
                </c:pt>
                <c:pt idx="37">
                  <c:v>Thiazole</c:v>
                </c:pt>
                <c:pt idx="38">
                  <c:v>3-Methyl-3-buten-1-ol </c:v>
                </c:pt>
                <c:pt idx="39">
                  <c:v>E-beta Ocimene </c:v>
                </c:pt>
                <c:pt idx="40">
                  <c:v>3-Methyl-2-butenyl acetate</c:v>
                </c:pt>
                <c:pt idx="41">
                  <c:v>Methyl-pyrazine</c:v>
                </c:pt>
                <c:pt idx="42">
                  <c:v>Dihydro-2-methyl-3(2H)-furanone</c:v>
                </c:pt>
                <c:pt idx="43">
                  <c:v>2,5-Dimethyl-1H-pyrrole</c:v>
                </c:pt>
                <c:pt idx="44">
                  <c:v> 3-Hydroxy-2-butanone</c:v>
                </c:pt>
                <c:pt idx="45">
                  <c:v>trans-2-Methyl-5-n-propenylfuran</c:v>
                </c:pt>
                <c:pt idx="46">
                  <c:v>1-Hydroxy-2-propanone</c:v>
                </c:pt>
                <c:pt idx="47">
                  <c:v>2,5-Dimethyl-pyrazine</c:v>
                </c:pt>
                <c:pt idx="48">
                  <c:v>2,6-Dimethyl-pyrazine</c:v>
                </c:pt>
                <c:pt idx="49">
                  <c:v>2-Ethyl-pyrazine </c:v>
                </c:pt>
                <c:pt idx="50">
                  <c:v>2,3-Dimethyl-Pyrazine+2-Hydroxyisobutyric acid  </c:v>
                </c:pt>
                <c:pt idx="51">
                  <c:v>2-Cyclopenten-1-one </c:v>
                </c:pt>
                <c:pt idx="52">
                  <c:v>Unknown 3</c:v>
                </c:pt>
                <c:pt idx="53">
                  <c:v>2-Hydroxy-3-pentanone </c:v>
                </c:pt>
                <c:pt idx="54">
                  <c:v>2-Methyl-2-cyclopenten-1-one </c:v>
                </c:pt>
                <c:pt idx="55">
                  <c:v>2-Ethyl-6-methyl-Pyrazine</c:v>
                </c:pt>
                <c:pt idx="56">
                  <c:v>2-Ethyl-5-methyl-Pyrazine</c:v>
                </c:pt>
                <c:pt idx="57">
                  <c:v>2,3,5-Trimethyl-Pyrazine  </c:v>
                </c:pt>
                <c:pt idx="58">
                  <c:v>2-Ethyl-3-methylpyrazine</c:v>
                </c:pt>
                <c:pt idx="59">
                  <c:v>2-Methyl-3(2H)furanon</c:v>
                </c:pt>
                <c:pt idx="60">
                  <c:v>2-(n-propyl)-Pyrazine</c:v>
                </c:pt>
                <c:pt idx="61">
                  <c:v>2,6-diethyl-Pyrazine</c:v>
                </c:pt>
                <c:pt idx="62">
                  <c:v>2-Furfurylthiol</c:v>
                </c:pt>
                <c:pt idx="63">
                  <c:v>2-ethyl-3,5-dimethyl-Pyrazine</c:v>
                </c:pt>
                <c:pt idx="64">
                  <c:v>Acetic acid </c:v>
                </c:pt>
                <c:pt idx="65">
                  <c:v>2,3-Diethylpyrazine </c:v>
                </c:pt>
                <c:pt idx="66">
                  <c:v>Furfural </c:v>
                </c:pt>
                <c:pt idx="67">
                  <c:v>trans-Linalool oxide</c:v>
                </c:pt>
                <c:pt idx="68">
                  <c:v>Acetoxyacetone</c:v>
                </c:pt>
                <c:pt idx="69">
                  <c:v>2-Methyl-6-vinyl pyrazine</c:v>
                </c:pt>
                <c:pt idx="70">
                  <c:v>Furfuryl methyl sulfide</c:v>
                </c:pt>
                <c:pt idx="71">
                  <c:v>3,5-Diethyl-2-methyl-pyrazine</c:v>
                </c:pt>
                <c:pt idx="72">
                  <c:v>2,5-Dimethyl-3(2H)-furanone</c:v>
                </c:pt>
                <c:pt idx="73">
                  <c:v>2,5-Hexanedione </c:v>
                </c:pt>
                <c:pt idx="74">
                  <c:v>2-Acetylfuran</c:v>
                </c:pt>
                <c:pt idx="75">
                  <c:v>4-Vinyltetrahydro-2H-pyran-2-one</c:v>
                </c:pt>
                <c:pt idx="76">
                  <c:v>1-(2-Furyl)-2-propanone</c:v>
                </c:pt>
                <c:pt idx="77">
                  <c:v>2,3-Dimethyl-2-cyclopenten-1-one </c:v>
                </c:pt>
                <c:pt idx="78">
                  <c:v>2-oxopropyl propanoate</c:v>
                </c:pt>
                <c:pt idx="79">
                  <c:v>1-Acetoxy-2-butanone</c:v>
                </c:pt>
                <c:pt idx="80">
                  <c:v>Furfuryl acetate</c:v>
                </c:pt>
                <c:pt idx="81">
                  <c:v>Propanoic acid </c:v>
                </c:pt>
                <c:pt idx="82">
                  <c:v> 5-Methyl-2-furancarboxaldehyde</c:v>
                </c:pt>
                <c:pt idx="83">
                  <c:v>2-Propionylfuran</c:v>
                </c:pt>
                <c:pt idx="84">
                  <c:v>(5-Methyl-2-furyl)methanethiol</c:v>
                </c:pt>
                <c:pt idx="85">
                  <c:v>(1-methylethenyl)-Pyrazine</c:v>
                </c:pt>
                <c:pt idx="86">
                  <c:v>2-Acetylpyridine</c:v>
                </c:pt>
                <c:pt idx="87">
                  <c:v>Furfuryl propanoate</c:v>
                </c:pt>
                <c:pt idx="88">
                  <c:v>5H-5-Methyl-6,7-dihydrocyclopentapyrazine</c:v>
                </c:pt>
                <c:pt idx="89">
                  <c:v>1-methyl 1H-Pyrrole-2-carboxaldehyde</c:v>
                </c:pt>
                <c:pt idx="90">
                  <c:v>4-hydroxy-butanoic acid</c:v>
                </c:pt>
                <c:pt idx="91">
                  <c:v>2-Isopropenylpyrazine</c:v>
                </c:pt>
                <c:pt idx="92">
                  <c:v>Butanoic acid</c:v>
                </c:pt>
                <c:pt idx="93">
                  <c:v>2,5-dihydro-3,5-dimethyl-2-Furanone</c:v>
                </c:pt>
                <c:pt idx="94">
                  <c:v>1-(2-Furyl)-butan-3-one </c:v>
                </c:pt>
                <c:pt idx="95">
                  <c:v>2-Acetyl-1-methylpyrrole</c:v>
                </c:pt>
                <c:pt idx="96">
                  <c:v>3-Mercapto-3-methyl-1-butanol</c:v>
                </c:pt>
                <c:pt idx="97">
                  <c:v>Furfuryl alcohol</c:v>
                </c:pt>
                <c:pt idx="98">
                  <c:v>3-Ethyl-2-hydroxy-2-cyclopenten-1-one</c:v>
                </c:pt>
                <c:pt idx="99">
                  <c:v>3-Methyl-butanoic acid</c:v>
                </c:pt>
                <c:pt idx="100">
                  <c:v>2-Furfuryl-5-methylfuran</c:v>
                </c:pt>
                <c:pt idx="101">
                  <c:v>Acetyl-6-methylpyrazine</c:v>
                </c:pt>
                <c:pt idx="102">
                  <c:v>Unknown 4</c:v>
                </c:pt>
                <c:pt idx="103">
                  <c:v>Unknown 5</c:v>
                </c:pt>
                <c:pt idx="104">
                  <c:v>N-acetyl-4(H)-Pyridine</c:v>
                </c:pt>
                <c:pt idx="105">
                  <c:v>3-Methoxy-2-methyl-cyclohex-2-enone</c:v>
                </c:pt>
                <c:pt idx="106">
                  <c:v>3-ethyl-4-methyl-2,5-Furandione</c:v>
                </c:pt>
                <c:pt idx="107">
                  <c:v>2(5H)-Furanone</c:v>
                </c:pt>
                <c:pt idx="108">
                  <c:v>Methyl salicylate</c:v>
                </c:pt>
                <c:pt idx="109">
                  <c:v>Unknown 6</c:v>
                </c:pt>
                <c:pt idx="110">
                  <c:v>Unknown 7</c:v>
                </c:pt>
                <c:pt idx="111">
                  <c:v>3,5-DIMETHYL CYCLOPENTENOLONE</c:v>
                </c:pt>
                <c:pt idx="112">
                  <c:v>Unknown 8</c:v>
                </c:pt>
                <c:pt idx="113">
                  <c:v>3-methyl-2-Butenoic acid</c:v>
                </c:pt>
                <c:pt idx="114">
                  <c:v>Unknown 9</c:v>
                </c:pt>
                <c:pt idx="115">
                  <c:v>2-hydroxy-3-methyl-2-Cyclopenten-1-one </c:v>
                </c:pt>
                <c:pt idx="116">
                  <c:v>1-(2-furanylmethyl)-1H-Pyrrole </c:v>
                </c:pt>
                <c:pt idx="117">
                  <c:v>Unknown 10</c:v>
                </c:pt>
                <c:pt idx="118">
                  <c:v>n-butylbenzoate</c:v>
                </c:pt>
                <c:pt idx="119">
                  <c:v>2-methoxy-Phenol </c:v>
                </c:pt>
                <c:pt idx="120">
                  <c:v>Unknown 11</c:v>
                </c:pt>
                <c:pt idx="121">
                  <c:v>3-ethyl-2-hydroxy- 2-Cyclopenten-1-one</c:v>
                </c:pt>
                <c:pt idx="122">
                  <c:v>Unknown 12</c:v>
                </c:pt>
                <c:pt idx="123">
                  <c:v>Phenylethyl Alcohol </c:v>
                </c:pt>
                <c:pt idx="124">
                  <c:v>2-Thiophenemethanol</c:v>
                </c:pt>
                <c:pt idx="125">
                  <c:v>Maltol </c:v>
                </c:pt>
                <c:pt idx="126">
                  <c:v>2-Acetylpyrrole</c:v>
                </c:pt>
                <c:pt idx="127">
                  <c:v>4(1H)-Quinazolinone </c:v>
                </c:pt>
                <c:pt idx="128">
                  <c:v>Difurfuryl ether</c:v>
                </c:pt>
                <c:pt idx="129">
                  <c:v>4-Hydroxy-3-methylacetophenone</c:v>
                </c:pt>
                <c:pt idx="130">
                  <c:v>Phenol </c:v>
                </c:pt>
                <c:pt idx="131">
                  <c:v>1H-Pyrrole-2-carboxaldehyde</c:v>
                </c:pt>
                <c:pt idx="132">
                  <c:v>4-ethyl guaiacol</c:v>
                </c:pt>
                <c:pt idx="133">
                  <c:v>2,5-Dimethyl-4-hydroxy-3(2H)-furanone (Furaneol)</c:v>
                </c:pt>
                <c:pt idx="134">
                  <c:v>5-Acetyldihydro-2(3H)-furanone (Solerone)</c:v>
                </c:pt>
                <c:pt idx="135">
                  <c:v>N-Methyl-2-formylpyrrol</c:v>
                </c:pt>
                <c:pt idx="136">
                  <c:v>Unknown 13</c:v>
                </c:pt>
                <c:pt idx="137">
                  <c:v>Nonanoic acid </c:v>
                </c:pt>
                <c:pt idx="138">
                  <c:v>2-Vinyl guaiacol</c:v>
                </c:pt>
                <c:pt idx="139">
                  <c:v>Unknown 14</c:v>
                </c:pt>
                <c:pt idx="140">
                  <c:v>n-Decanoic acid </c:v>
                </c:pt>
                <c:pt idx="141">
                  <c:v>2-Benzofuran-1(3H)-one</c:v>
                </c:pt>
                <c:pt idx="142">
                  <c:v>2,3-dihydro-Benzofuran</c:v>
                </c:pt>
                <c:pt idx="143">
                  <c:v>Unknown 15</c:v>
                </c:pt>
                <c:pt idx="144">
                  <c:v>Indole</c:v>
                </c:pt>
                <c:pt idx="145">
                  <c:v>Benzoic acid</c:v>
                </c:pt>
                <c:pt idx="146">
                  <c:v>5-(Hydroxymethyl)dihydro-2(3H)-furanone</c:v>
                </c:pt>
              </c:strCache>
            </c:strRef>
          </c:cat>
          <c:val>
            <c:numRef>
              <c:f>'[giugno capsule e moka_EL.xlsx]Oro'!$AM$161:$AM$307</c:f>
              <c:numCache>
                <c:formatCode>0.0</c:formatCode>
                <c:ptCount val="147"/>
                <c:pt idx="0">
                  <c:v>-97.267416608924208</c:v>
                </c:pt>
                <c:pt idx="1">
                  <c:v>-100</c:v>
                </c:pt>
                <c:pt idx="2">
                  <c:v>0</c:v>
                </c:pt>
                <c:pt idx="3">
                  <c:v>-99.547083914636829</c:v>
                </c:pt>
                <c:pt idx="4">
                  <c:v>0</c:v>
                </c:pt>
                <c:pt idx="5">
                  <c:v>-98.097997949994337</c:v>
                </c:pt>
                <c:pt idx="6">
                  <c:v>95.039823468777911</c:v>
                </c:pt>
                <c:pt idx="7">
                  <c:v>-99.570664050953567</c:v>
                </c:pt>
                <c:pt idx="8">
                  <c:v>-99.371531126808321</c:v>
                </c:pt>
                <c:pt idx="9">
                  <c:v>-100</c:v>
                </c:pt>
                <c:pt idx="10">
                  <c:v>-62.274253314297859</c:v>
                </c:pt>
                <c:pt idx="11">
                  <c:v>-100</c:v>
                </c:pt>
                <c:pt idx="12">
                  <c:v>-97.219693190825097</c:v>
                </c:pt>
                <c:pt idx="13">
                  <c:v>-100</c:v>
                </c:pt>
                <c:pt idx="14">
                  <c:v>-100</c:v>
                </c:pt>
                <c:pt idx="15">
                  <c:v>-61.2276094950304</c:v>
                </c:pt>
                <c:pt idx="16">
                  <c:v>-100</c:v>
                </c:pt>
                <c:pt idx="17">
                  <c:v>-100</c:v>
                </c:pt>
                <c:pt idx="18">
                  <c:v>-99.440857468247017</c:v>
                </c:pt>
                <c:pt idx="19">
                  <c:v>-100</c:v>
                </c:pt>
                <c:pt idx="20">
                  <c:v>-100</c:v>
                </c:pt>
                <c:pt idx="21">
                  <c:v>-62.17212955654189</c:v>
                </c:pt>
                <c:pt idx="22">
                  <c:v>0</c:v>
                </c:pt>
                <c:pt idx="23">
                  <c:v>0</c:v>
                </c:pt>
                <c:pt idx="24">
                  <c:v>-100</c:v>
                </c:pt>
                <c:pt idx="25">
                  <c:v>-100</c:v>
                </c:pt>
                <c:pt idx="26">
                  <c:v>-100</c:v>
                </c:pt>
                <c:pt idx="27">
                  <c:v>-99.266075229985091</c:v>
                </c:pt>
                <c:pt idx="28">
                  <c:v>-100</c:v>
                </c:pt>
                <c:pt idx="29">
                  <c:v>-99.622571311579875</c:v>
                </c:pt>
                <c:pt idx="30">
                  <c:v>-93.486268015360665</c:v>
                </c:pt>
                <c:pt idx="31">
                  <c:v>-91.20240176233392</c:v>
                </c:pt>
                <c:pt idx="32">
                  <c:v>-54.756626747752335</c:v>
                </c:pt>
                <c:pt idx="33">
                  <c:v>-93.843211489568446</c:v>
                </c:pt>
                <c:pt idx="34">
                  <c:v>178.85218814897911</c:v>
                </c:pt>
                <c:pt idx="35">
                  <c:v>-27.125956525783195</c:v>
                </c:pt>
                <c:pt idx="36">
                  <c:v>-100</c:v>
                </c:pt>
                <c:pt idx="37">
                  <c:v>-100</c:v>
                </c:pt>
                <c:pt idx="38">
                  <c:v>-100</c:v>
                </c:pt>
                <c:pt idx="39">
                  <c:v>-78.070224644950116</c:v>
                </c:pt>
                <c:pt idx="40">
                  <c:v>-100</c:v>
                </c:pt>
                <c:pt idx="41">
                  <c:v>-88.204237954585935</c:v>
                </c:pt>
                <c:pt idx="42">
                  <c:v>-96.012838392541283</c:v>
                </c:pt>
                <c:pt idx="43">
                  <c:v>-100</c:v>
                </c:pt>
                <c:pt idx="44">
                  <c:v>-77.638731162519534</c:v>
                </c:pt>
                <c:pt idx="45">
                  <c:v>-100</c:v>
                </c:pt>
                <c:pt idx="46">
                  <c:v>-52.636979950346621</c:v>
                </c:pt>
                <c:pt idx="47">
                  <c:v>-81.372206345997213</c:v>
                </c:pt>
                <c:pt idx="48">
                  <c:v>-83.134224501217574</c:v>
                </c:pt>
                <c:pt idx="49">
                  <c:v>-85.999754666636051</c:v>
                </c:pt>
                <c:pt idx="50">
                  <c:v>-81.228469411602433</c:v>
                </c:pt>
                <c:pt idx="51">
                  <c:v>-80.816438930246633</c:v>
                </c:pt>
                <c:pt idx="52">
                  <c:v>-84.096986996474797</c:v>
                </c:pt>
                <c:pt idx="53">
                  <c:v>-79.273338305400713</c:v>
                </c:pt>
                <c:pt idx="54">
                  <c:v>-80.088481242586056</c:v>
                </c:pt>
                <c:pt idx="55">
                  <c:v>-70.209622110456777</c:v>
                </c:pt>
                <c:pt idx="56">
                  <c:v>-65.207090890842665</c:v>
                </c:pt>
                <c:pt idx="57">
                  <c:v>-50.681584671776982</c:v>
                </c:pt>
                <c:pt idx="58">
                  <c:v>-64.465223261138775</c:v>
                </c:pt>
                <c:pt idx="59">
                  <c:v>-95.559747121880278</c:v>
                </c:pt>
                <c:pt idx="60">
                  <c:v>-64.405640506112562</c:v>
                </c:pt>
                <c:pt idx="61">
                  <c:v>-44.715035426359748</c:v>
                </c:pt>
                <c:pt idx="62">
                  <c:v>-100</c:v>
                </c:pt>
                <c:pt idx="63">
                  <c:v>-38.717297937514104</c:v>
                </c:pt>
                <c:pt idx="64">
                  <c:v>81.923885083019769</c:v>
                </c:pt>
                <c:pt idx="65">
                  <c:v>-44.821293938963507</c:v>
                </c:pt>
                <c:pt idx="66">
                  <c:v>-68.787437647905904</c:v>
                </c:pt>
                <c:pt idx="67">
                  <c:v>-20.502083541111681</c:v>
                </c:pt>
                <c:pt idx="68">
                  <c:v>-56.867310028566841</c:v>
                </c:pt>
                <c:pt idx="69">
                  <c:v>-73.051354272047661</c:v>
                </c:pt>
                <c:pt idx="70">
                  <c:v>-100</c:v>
                </c:pt>
                <c:pt idx="71">
                  <c:v>-19.68542452899009</c:v>
                </c:pt>
                <c:pt idx="72">
                  <c:v>-83.621588862626851</c:v>
                </c:pt>
                <c:pt idx="73">
                  <c:v>-20.815588364785018</c:v>
                </c:pt>
                <c:pt idx="74">
                  <c:v>-53.667444577023495</c:v>
                </c:pt>
                <c:pt idx="75">
                  <c:v>-98.018266488313017</c:v>
                </c:pt>
                <c:pt idx="76">
                  <c:v>-94.752843994973802</c:v>
                </c:pt>
                <c:pt idx="77">
                  <c:v>-33.810858168071931</c:v>
                </c:pt>
                <c:pt idx="78">
                  <c:v>-47.937457737162248</c:v>
                </c:pt>
                <c:pt idx="79">
                  <c:v>-43.869968010455253</c:v>
                </c:pt>
                <c:pt idx="80">
                  <c:v>-58.767525988064108</c:v>
                </c:pt>
                <c:pt idx="81">
                  <c:v>164.68899899695484</c:v>
                </c:pt>
                <c:pt idx="82">
                  <c:v>-34.66595271640891</c:v>
                </c:pt>
                <c:pt idx="83">
                  <c:v>-40.958290328728673</c:v>
                </c:pt>
                <c:pt idx="84">
                  <c:v>-93.813554232608041</c:v>
                </c:pt>
                <c:pt idx="85">
                  <c:v>-28.972688187318035</c:v>
                </c:pt>
                <c:pt idx="86">
                  <c:v>-47.445997227726089</c:v>
                </c:pt>
                <c:pt idx="87">
                  <c:v>-23.441205182666526</c:v>
                </c:pt>
                <c:pt idx="88">
                  <c:v>-24.49226333655324</c:v>
                </c:pt>
                <c:pt idx="89">
                  <c:v>-36.139290563715463</c:v>
                </c:pt>
                <c:pt idx="90">
                  <c:v>81.260261309046555</c:v>
                </c:pt>
                <c:pt idx="91">
                  <c:v>-21.15956647776677</c:v>
                </c:pt>
                <c:pt idx="92">
                  <c:v>0</c:v>
                </c:pt>
                <c:pt idx="93">
                  <c:v>-9.306019802363771</c:v>
                </c:pt>
                <c:pt idx="94">
                  <c:v>-23.966560530977986</c:v>
                </c:pt>
                <c:pt idx="95">
                  <c:v>-24.953384404356406</c:v>
                </c:pt>
                <c:pt idx="96">
                  <c:v>-100</c:v>
                </c:pt>
                <c:pt idx="97">
                  <c:v>30.775178233840673</c:v>
                </c:pt>
                <c:pt idx="98">
                  <c:v>-19.181992702074389</c:v>
                </c:pt>
                <c:pt idx="99">
                  <c:v>15.300402124603071</c:v>
                </c:pt>
                <c:pt idx="100">
                  <c:v>0</c:v>
                </c:pt>
                <c:pt idx="101">
                  <c:v>-14.336542636332444</c:v>
                </c:pt>
                <c:pt idx="102">
                  <c:v>-15.08862959237281</c:v>
                </c:pt>
                <c:pt idx="103">
                  <c:v>-7.1612264069246647</c:v>
                </c:pt>
                <c:pt idx="104">
                  <c:v>-53.738663734520607</c:v>
                </c:pt>
                <c:pt idx="105">
                  <c:v>-69.296821587164004</c:v>
                </c:pt>
                <c:pt idx="106">
                  <c:v>-17.652311658366973</c:v>
                </c:pt>
                <c:pt idx="107">
                  <c:v>0</c:v>
                </c:pt>
                <c:pt idx="108">
                  <c:v>0</c:v>
                </c:pt>
                <c:pt idx="109">
                  <c:v>-13.926868933853626</c:v>
                </c:pt>
                <c:pt idx="110">
                  <c:v>-93.789972667009707</c:v>
                </c:pt>
                <c:pt idx="111">
                  <c:v>4.0000504762602729</c:v>
                </c:pt>
                <c:pt idx="112">
                  <c:v>-33.534458737766556</c:v>
                </c:pt>
                <c:pt idx="113">
                  <c:v>0</c:v>
                </c:pt>
                <c:pt idx="114">
                  <c:v>3.66936772503451E-2</c:v>
                </c:pt>
                <c:pt idx="115">
                  <c:v>28.856686130209809</c:v>
                </c:pt>
                <c:pt idx="116">
                  <c:v>-14.568117510019531</c:v>
                </c:pt>
                <c:pt idx="117">
                  <c:v>-84.91925884266756</c:v>
                </c:pt>
                <c:pt idx="118">
                  <c:v>3.8756685889794196</c:v>
                </c:pt>
                <c:pt idx="119">
                  <c:v>6.0044798427303272</c:v>
                </c:pt>
                <c:pt idx="120">
                  <c:v>-9.3828894659433129</c:v>
                </c:pt>
                <c:pt idx="121">
                  <c:v>6.7919396052627246</c:v>
                </c:pt>
                <c:pt idx="122">
                  <c:v>-49.8993944501564</c:v>
                </c:pt>
                <c:pt idx="123">
                  <c:v>9.1037239895472712</c:v>
                </c:pt>
                <c:pt idx="124">
                  <c:v>60.086352302252756</c:v>
                </c:pt>
                <c:pt idx="125">
                  <c:v>49.276604451601663</c:v>
                </c:pt>
                <c:pt idx="126">
                  <c:v>56.639477827443606</c:v>
                </c:pt>
                <c:pt idx="127">
                  <c:v>-6.3728150940078336</c:v>
                </c:pt>
                <c:pt idx="128">
                  <c:v>1.1240119192696674</c:v>
                </c:pt>
                <c:pt idx="129">
                  <c:v>-1.3689254261064023</c:v>
                </c:pt>
                <c:pt idx="130">
                  <c:v>79.786879855627831</c:v>
                </c:pt>
                <c:pt idx="131">
                  <c:v>133.27186316653078</c:v>
                </c:pt>
                <c:pt idx="132">
                  <c:v>-3.2670701606763073</c:v>
                </c:pt>
                <c:pt idx="133">
                  <c:v>-100</c:v>
                </c:pt>
                <c:pt idx="134">
                  <c:v>6.7128183411310394</c:v>
                </c:pt>
                <c:pt idx="135">
                  <c:v>59.352197244223284</c:v>
                </c:pt>
                <c:pt idx="136">
                  <c:v>-100</c:v>
                </c:pt>
                <c:pt idx="137">
                  <c:v>-52.338597463057582</c:v>
                </c:pt>
                <c:pt idx="138">
                  <c:v>-60.058637966145042</c:v>
                </c:pt>
                <c:pt idx="139">
                  <c:v>-2.3041577801082234</c:v>
                </c:pt>
                <c:pt idx="140">
                  <c:v>-7.8994833752814912</c:v>
                </c:pt>
                <c:pt idx="141">
                  <c:v>20.234766338471797</c:v>
                </c:pt>
                <c:pt idx="142">
                  <c:v>-69.612223274567683</c:v>
                </c:pt>
                <c:pt idx="143">
                  <c:v>0</c:v>
                </c:pt>
                <c:pt idx="144">
                  <c:v>-52.193327497325171</c:v>
                </c:pt>
                <c:pt idx="145">
                  <c:v>0</c:v>
                </c:pt>
                <c:pt idx="146">
                  <c:v>227.899972543482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E8-4381-8667-B37067FD97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5654096"/>
        <c:axId val="15661168"/>
      </c:barChart>
      <c:catAx>
        <c:axId val="1565409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661168"/>
        <c:crosses val="autoZero"/>
        <c:auto val="1"/>
        <c:lblAlgn val="ctr"/>
        <c:lblOffset val="100"/>
        <c:noMultiLvlLbl val="0"/>
      </c:catAx>
      <c:valAx>
        <c:axId val="15661168"/>
        <c:scaling>
          <c:orientation val="minMax"/>
          <c:max val="150"/>
          <c:min val="-1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5654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986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7954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5048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7466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08106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019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8859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742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1634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9880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4692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D260E-213C-42C9-B4BD-BA2C67543ACF}" type="datetimeFigureOut">
              <a:rPr lang="it-IT" smtClean="0"/>
              <a:t>22/11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B5A35-7F8A-45A3-95F6-50B49008C00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9822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278296" y="318052"/>
            <a:ext cx="6029739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Potential </a:t>
            </a:r>
            <a:r>
              <a:rPr lang="en-GB" b="1"/>
              <a:t>Aroma </a:t>
            </a:r>
            <a:r>
              <a:rPr lang="en-GB" b="1" smtClean="0"/>
              <a:t>Chemical Fingerprint </a:t>
            </a:r>
            <a:r>
              <a:rPr lang="en-GB" b="1" dirty="0"/>
              <a:t>Of Oxidised Coffee Note by HS-SPME-GC-MS and machine learning </a:t>
            </a:r>
            <a:endParaRPr lang="it-IT" b="1" dirty="0"/>
          </a:p>
          <a:p>
            <a:r>
              <a:rPr lang="it-IT" dirty="0" smtClean="0"/>
              <a:t>Giulia </a:t>
            </a:r>
            <a:r>
              <a:rPr lang="it-IT" dirty="0" err="1"/>
              <a:t>Strocchi</a:t>
            </a:r>
            <a:r>
              <a:rPr lang="it-IT" baseline="30000" dirty="0"/>
              <a:t> a</a:t>
            </a:r>
            <a:r>
              <a:rPr lang="it-IT" dirty="0"/>
              <a:t>, Eloisa </a:t>
            </a:r>
            <a:r>
              <a:rPr lang="it-IT" dirty="0" err="1"/>
              <a:t>Bagnulo</a:t>
            </a:r>
            <a:r>
              <a:rPr lang="it-IT" baseline="30000" dirty="0" err="1"/>
              <a:t>a</a:t>
            </a:r>
            <a:r>
              <a:rPr lang="it-IT" dirty="0"/>
              <a:t>, Manuela R. </a:t>
            </a:r>
            <a:r>
              <a:rPr lang="it-IT" dirty="0" err="1"/>
              <a:t>Ruosi</a:t>
            </a:r>
            <a:r>
              <a:rPr lang="it-IT" baseline="30000" dirty="0"/>
              <a:t> b</a:t>
            </a:r>
            <a:r>
              <a:rPr lang="it-IT" dirty="0"/>
              <a:t>, Giulia </a:t>
            </a:r>
            <a:r>
              <a:rPr lang="it-IT" dirty="0" err="1"/>
              <a:t>Ravaioli</a:t>
            </a:r>
            <a:r>
              <a:rPr lang="it-IT" baseline="30000" dirty="0" err="1"/>
              <a:t>b</a:t>
            </a:r>
            <a:r>
              <a:rPr lang="it-IT" dirty="0"/>
              <a:t>, Francesca Trapani</a:t>
            </a:r>
            <a:r>
              <a:rPr lang="it-IT" baseline="30000" dirty="0"/>
              <a:t> b</a:t>
            </a:r>
            <a:r>
              <a:rPr lang="it-IT" dirty="0"/>
              <a:t>, Carlo </a:t>
            </a:r>
            <a:r>
              <a:rPr lang="it-IT" dirty="0" err="1"/>
              <a:t>Bicchi</a:t>
            </a:r>
            <a:r>
              <a:rPr lang="it-IT" baseline="30000" dirty="0"/>
              <a:t> a</a:t>
            </a:r>
            <a:r>
              <a:rPr lang="it-IT" dirty="0"/>
              <a:t>, Gloria Pellegrino</a:t>
            </a:r>
            <a:r>
              <a:rPr lang="it-IT" baseline="30000" dirty="0"/>
              <a:t> b</a:t>
            </a:r>
            <a:r>
              <a:rPr lang="it-IT" dirty="0"/>
              <a:t>, Erica Liberto</a:t>
            </a:r>
            <a:r>
              <a:rPr lang="it-IT" baseline="30000" dirty="0"/>
              <a:t> a</a:t>
            </a:r>
            <a:r>
              <a:rPr lang="it-IT" dirty="0"/>
              <a:t>*</a:t>
            </a:r>
          </a:p>
          <a:p>
            <a:r>
              <a:rPr lang="it-IT" baseline="30000" dirty="0"/>
              <a:t> </a:t>
            </a:r>
            <a:endParaRPr lang="it-IT" dirty="0"/>
          </a:p>
          <a:p>
            <a:r>
              <a:rPr lang="it-IT" baseline="30000" dirty="0"/>
              <a:t>a </a:t>
            </a:r>
            <a:r>
              <a:rPr lang="it-IT" dirty="0"/>
              <a:t>Dipartimento di Scienza e Tecnologia del Farmaco, Università degli Studi di Torino, Via Pietro Giuria 9, </a:t>
            </a:r>
            <a:r>
              <a:rPr lang="it-IT" dirty="0" err="1"/>
              <a:t>Turin</a:t>
            </a:r>
            <a:r>
              <a:rPr lang="it-IT" dirty="0"/>
              <a:t>, </a:t>
            </a:r>
            <a:r>
              <a:rPr lang="it-IT" dirty="0" err="1"/>
              <a:t>Italy</a:t>
            </a:r>
            <a:r>
              <a:rPr lang="it-IT" dirty="0"/>
              <a:t> </a:t>
            </a:r>
          </a:p>
          <a:p>
            <a:r>
              <a:rPr lang="it-IT" baseline="30000" dirty="0"/>
              <a:t>b</a:t>
            </a:r>
            <a:r>
              <a:rPr lang="it-IT" dirty="0"/>
              <a:t> Luigi Lavazza S.p.A., Strada Settimo 410, </a:t>
            </a:r>
            <a:r>
              <a:rPr lang="it-IT" dirty="0" err="1"/>
              <a:t>Turin</a:t>
            </a:r>
            <a:r>
              <a:rPr lang="it-IT" dirty="0"/>
              <a:t>, </a:t>
            </a:r>
            <a:r>
              <a:rPr lang="it-IT" dirty="0" err="1"/>
              <a:t>Italy</a:t>
            </a:r>
            <a:endParaRPr lang="it-IT" dirty="0"/>
          </a:p>
          <a:p>
            <a:r>
              <a:rPr lang="it-IT" dirty="0"/>
              <a:t> </a:t>
            </a:r>
          </a:p>
          <a:p>
            <a:r>
              <a:rPr lang="it-IT" dirty="0"/>
              <a:t> </a:t>
            </a:r>
          </a:p>
          <a:p>
            <a:r>
              <a:rPr lang="en-GB" dirty="0"/>
              <a:t>*Corresponding author: erica.liberto@unito.it</a:t>
            </a:r>
            <a:endParaRPr lang="it-IT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426906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asellaDiTesto 14"/>
          <p:cNvSpPr txBox="1"/>
          <p:nvPr/>
        </p:nvSpPr>
        <p:spPr>
          <a:xfrm>
            <a:off x="223497" y="230860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Figure S1</a:t>
            </a:r>
            <a:endParaRPr lang="it-IT" sz="1400" b="1" dirty="0"/>
          </a:p>
        </p:txBody>
      </p:sp>
      <p:grpSp>
        <p:nvGrpSpPr>
          <p:cNvPr id="29" name="Gruppo 28"/>
          <p:cNvGrpSpPr/>
          <p:nvPr/>
        </p:nvGrpSpPr>
        <p:grpSpPr>
          <a:xfrm>
            <a:off x="999287" y="498"/>
            <a:ext cx="5426053" cy="9905502"/>
            <a:chOff x="1457739" y="498"/>
            <a:chExt cx="4967601" cy="9905502"/>
          </a:xfrm>
        </p:grpSpPr>
        <p:grpSp>
          <p:nvGrpSpPr>
            <p:cNvPr id="9" name="Gruppo 8"/>
            <p:cNvGrpSpPr>
              <a:grpSpLocks noChangeAspect="1"/>
            </p:cNvGrpSpPr>
            <p:nvPr/>
          </p:nvGrpSpPr>
          <p:grpSpPr>
            <a:xfrm>
              <a:off x="1457739" y="498"/>
              <a:ext cx="4967601" cy="9905502"/>
              <a:chOff x="2268" y="-154686"/>
              <a:chExt cx="7692910" cy="15339821"/>
            </a:xfrm>
          </p:grpSpPr>
          <p:grpSp>
            <p:nvGrpSpPr>
              <p:cNvPr id="10" name="Gruppo 9"/>
              <p:cNvGrpSpPr/>
              <p:nvPr/>
            </p:nvGrpSpPr>
            <p:grpSpPr>
              <a:xfrm>
                <a:off x="2268" y="3716515"/>
                <a:ext cx="7692222" cy="11468620"/>
                <a:chOff x="3398" y="3542284"/>
                <a:chExt cx="11528532" cy="15912724"/>
              </a:xfrm>
            </p:grpSpPr>
            <p:graphicFrame>
              <p:nvGraphicFramePr>
                <p:cNvPr id="12" name="Grafico 11"/>
                <p:cNvGraphicFramePr/>
                <p:nvPr>
                  <p:extLst>
                    <p:ext uri="{D42A27DB-BD31-4B8C-83A1-F6EECF244321}">
                      <p14:modId xmlns:p14="http://schemas.microsoft.com/office/powerpoint/2010/main" val="2247622339"/>
                    </p:ext>
                  </p:extLst>
                </p:nvPr>
              </p:nvGraphicFramePr>
              <p:xfrm>
                <a:off x="40730" y="3542284"/>
                <a:ext cx="11491200" cy="5626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13" name="Grafico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34676581"/>
                    </p:ext>
                  </p:extLst>
                </p:nvPr>
              </p:nvGraphicFramePr>
              <p:xfrm>
                <a:off x="3398" y="8714984"/>
                <a:ext cx="11491201" cy="56268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14" name="Grafico 1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53787119"/>
                    </p:ext>
                  </p:extLst>
                </p:nvPr>
              </p:nvGraphicFramePr>
              <p:xfrm>
                <a:off x="3398" y="13828206"/>
                <a:ext cx="11491200" cy="562680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p:grpSp>
          <p:graphicFrame>
            <p:nvGraphicFramePr>
              <p:cNvPr id="11" name="Grafico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05097526"/>
                  </p:ext>
                </p:extLst>
              </p:nvPr>
            </p:nvGraphicFramePr>
            <p:xfrm>
              <a:off x="27177" y="-154686"/>
              <a:ext cx="7668001" cy="4057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pic>
          <p:nvPicPr>
            <p:cNvPr id="16" name="Immagine 15"/>
            <p:cNvPicPr>
              <a:picLocks noChangeAspect="1"/>
            </p:cNvPicPr>
            <p:nvPr/>
          </p:nvPicPr>
          <p:blipFill rotWithShape="1">
            <a:blip r:embed="rId6"/>
            <a:srcRect l="852" r="28246" b="-1422"/>
            <a:stretch/>
          </p:blipFill>
          <p:spPr>
            <a:xfrm>
              <a:off x="1824438" y="1310441"/>
              <a:ext cx="4478996" cy="315159"/>
            </a:xfrm>
            <a:prstGeom prst="rect">
              <a:avLst/>
            </a:prstGeom>
          </p:spPr>
        </p:pic>
        <p:pic>
          <p:nvPicPr>
            <p:cNvPr id="22" name="Immagine 21"/>
            <p:cNvPicPr>
              <a:picLocks noChangeAspect="1"/>
            </p:cNvPicPr>
            <p:nvPr/>
          </p:nvPicPr>
          <p:blipFill rotWithShape="1">
            <a:blip r:embed="rId6"/>
            <a:srcRect l="852" r="28246" b="-1422"/>
            <a:stretch/>
          </p:blipFill>
          <p:spPr>
            <a:xfrm>
              <a:off x="1831861" y="6223975"/>
              <a:ext cx="4478996" cy="326404"/>
            </a:xfrm>
            <a:prstGeom prst="rect">
              <a:avLst/>
            </a:prstGeom>
          </p:spPr>
        </p:pic>
        <p:pic>
          <p:nvPicPr>
            <p:cNvPr id="23" name="Immagine 22"/>
            <p:cNvPicPr>
              <a:picLocks noChangeAspect="1"/>
            </p:cNvPicPr>
            <p:nvPr/>
          </p:nvPicPr>
          <p:blipFill rotWithShape="1">
            <a:blip r:embed="rId6"/>
            <a:srcRect l="852" r="28246" b="-1422"/>
            <a:stretch/>
          </p:blipFill>
          <p:spPr>
            <a:xfrm>
              <a:off x="1824438" y="3796279"/>
              <a:ext cx="4478996" cy="308643"/>
            </a:xfrm>
            <a:prstGeom prst="rect">
              <a:avLst/>
            </a:prstGeom>
          </p:spPr>
        </p:pic>
        <p:pic>
          <p:nvPicPr>
            <p:cNvPr id="24" name="Immagine 23"/>
            <p:cNvPicPr>
              <a:picLocks noChangeAspect="1"/>
            </p:cNvPicPr>
            <p:nvPr/>
          </p:nvPicPr>
          <p:blipFill rotWithShape="1">
            <a:blip r:embed="rId6"/>
            <a:srcRect l="852" r="28246" b="-1422"/>
            <a:stretch/>
          </p:blipFill>
          <p:spPr>
            <a:xfrm>
              <a:off x="1824438" y="8103228"/>
              <a:ext cx="4478996" cy="320054"/>
            </a:xfrm>
            <a:prstGeom prst="rect">
              <a:avLst/>
            </a:prstGeom>
          </p:spPr>
        </p:pic>
        <p:sp>
          <p:nvSpPr>
            <p:cNvPr id="25" name="CasellaDiTesto 24"/>
            <p:cNvSpPr txBox="1"/>
            <p:nvPr/>
          </p:nvSpPr>
          <p:spPr>
            <a:xfrm>
              <a:off x="1824438" y="107749"/>
              <a:ext cx="3080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a)</a:t>
              </a:r>
              <a:endParaRPr lang="it-IT" sz="1200" b="1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1824438" y="2620385"/>
              <a:ext cx="3161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b)</a:t>
              </a:r>
              <a:endParaRPr lang="it-IT" sz="1200" b="1" dirty="0"/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1824438" y="5017759"/>
              <a:ext cx="3080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c)</a:t>
              </a:r>
              <a:endParaRPr lang="it-IT" sz="1200" b="1" dirty="0"/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1824438" y="7364834"/>
              <a:ext cx="3161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d)</a:t>
              </a:r>
              <a:endParaRPr lang="it-IT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2663372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4</Words>
  <Application>Microsoft Office PowerPoint</Application>
  <PresentationFormat>A4 (21x29,7 cm)</PresentationFormat>
  <Paragraphs>17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IBERTO</dc:creator>
  <cp:lastModifiedBy>DSTF</cp:lastModifiedBy>
  <cp:revision>22</cp:revision>
  <dcterms:created xsi:type="dcterms:W3CDTF">2021-12-30T20:40:09Z</dcterms:created>
  <dcterms:modified xsi:type="dcterms:W3CDTF">2022-11-22T13:30:29Z</dcterms:modified>
</cp:coreProperties>
</file>